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4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32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60472E-CE76-B474-5789-4F6CDA18D8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7ED8CB-544C-3DC1-38CD-D2116AD34F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E28E6-CEC1-AC3A-F284-7B8A91C15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58708B-6DFD-63EF-4D65-6E4F2C1B9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EDA411-EFE3-04BA-DC94-3541F8ABD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900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7148D5-8474-94A4-4A6D-8693E94428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B843C4-A64E-8B49-3314-F118314DC5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CD0A75-5F41-7E8D-3AB6-162AC3EE0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AFF921-5AAC-1766-DE1B-426505AD1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55DB1E-CBC3-F847-B93C-E16B6DE11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854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FC3040-EBDA-AE24-9785-E35CC7BE6E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B06338-9A79-1094-D5F0-63C3E4F863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C2FAD7-5C33-4CF2-7196-EFCADEB4A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C850C9-D58D-C4FA-8BB6-EE88990EA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EF8DFD-0DBB-BC22-6615-C414742C8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893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E3AE9-29C2-E0DC-7393-A3B42787B9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567D59-C383-1FE7-0486-DD66C8AF3A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2857B5-CC3F-BB46-41E0-1B7B454AE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B3667B-A00F-9700-13E4-98D90B72F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1A891-947A-C431-1AFB-71CADF129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963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BF6900-E7A2-7631-92C4-05A6BAD80D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889227-E0D0-2D5C-A22E-7748BAE88B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A1EBFF-EC4C-AC8B-5083-9C1E60F94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FEADC5-8AF3-64F1-009A-F7A3737A0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65A204-353C-4E9C-F079-D113CC045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449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B3ECCA-CA20-D567-F78F-483AE9D76B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1C9D34-F3AC-4277-55D5-810E11A778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9E2E0D-8589-05FB-CEA6-32C7B17B09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6B3141-2041-0B3A-C71A-7668EF38B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9FB43A-D303-CFF1-5BC6-ECDB910F7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22696E-AED7-29CC-EA19-7B59F967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875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01836-029B-922D-CAE7-FBEC5B0217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E48164-4FC6-DD04-75DD-F89D83AB9C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2A6EAF-2AF4-2956-44CC-1F9E4BAEB9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AC8A540-F982-F2C5-74BC-088237E5DA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9D25525-86DE-1973-21C9-AFDA66126B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4E61A3-C429-C159-7FB2-79E164FB8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435D92-FCBC-672A-0890-45F0A5C5F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3AE9BC-98CE-E948-734E-444057FA9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90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0D7079-F6DF-1C60-933C-881A7F06FF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BC09E0-6156-1736-4989-71826A25F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6C43D4-2F61-16A6-852B-6749E8DD6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70D0F6-C2E7-95ED-A8BC-A49027139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262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E1DADA-FFAF-F32E-F101-36B42C1CE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E077DF-2935-1EC4-7758-92895B608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5F14FD-D6EB-B767-B110-57688F300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874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30C991-7171-84EE-F17B-D9EAB224B3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7E5753-945D-46FD-0BEC-FE2E6E74D9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93CB4C-BABC-3F09-FC94-361AB80C88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315E22-94A4-4FEE-BF0B-C7FC51191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23874D-67A5-A189-39CF-6FA12C854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7B24A3-3755-7B7E-1BF3-3DCE05742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278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BF16D7-CA65-0D71-9943-91912FFC1D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09526E6-EC70-13A5-6634-12A11B33AD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39D4A2-2F6F-9E2D-5855-EC207968D1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724D3A-58B9-334C-B042-4C2E7F056C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F74060-6B78-E910-70EC-5EA30226B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AFCB13-AAFA-4B09-6AC1-B300E81DD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208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20FE57C-C0B9-4540-026C-C636F11963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C197A-DD57-468E-615B-494B817325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2EDF51-379D-EA59-7A43-1049670FAB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2FDC9E-8C06-41C3-A012-531BA803727A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FE3E76-D9CB-C88C-9211-86212A5CB0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0A4CC0-5DA2-37CA-2AAB-D8541EB9EA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D3D500-84FC-4153-A735-58FB432D0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479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7" name="Group 126">
            <a:extLst>
              <a:ext uri="{FF2B5EF4-FFF2-40B4-BE49-F238E27FC236}">
                <a16:creationId xmlns:a16="http://schemas.microsoft.com/office/drawing/2014/main" id="{B137E683-4E03-1E3E-5A87-983297596FBC}"/>
              </a:ext>
            </a:extLst>
          </p:cNvPr>
          <p:cNvGrpSpPr/>
          <p:nvPr/>
        </p:nvGrpSpPr>
        <p:grpSpPr>
          <a:xfrm>
            <a:off x="1345674" y="1134006"/>
            <a:ext cx="9593720" cy="5026388"/>
            <a:chOff x="1345674" y="1134006"/>
            <a:chExt cx="9593720" cy="5026388"/>
          </a:xfrm>
        </p:grpSpPr>
        <p:sp>
          <p:nvSpPr>
            <p:cNvPr id="117" name="Oval 8">
              <a:extLst>
                <a:ext uri="{FF2B5EF4-FFF2-40B4-BE49-F238E27FC236}">
                  <a16:creationId xmlns:a16="http://schemas.microsoft.com/office/drawing/2014/main" id="{D3F14679-9D2D-9145-BCF7-687DCAD24A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7868" y="3175525"/>
              <a:ext cx="959964" cy="914416"/>
            </a:xfrm>
            <a:prstGeom prst="ellipse">
              <a:avLst/>
            </a:prstGeom>
            <a:solidFill>
              <a:srgbClr val="66FF33"/>
            </a:solidFill>
            <a:ln w="12700" algn="ctr">
              <a:solidFill>
                <a:srgbClr val="FF9933"/>
              </a:solidFill>
              <a:round/>
              <a:headEnd/>
              <a:tailEnd/>
            </a:ln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118" name="Oval 9">
              <a:extLst>
                <a:ext uri="{FF2B5EF4-FFF2-40B4-BE49-F238E27FC236}">
                  <a16:creationId xmlns:a16="http://schemas.microsoft.com/office/drawing/2014/main" id="{A2089B1A-D6D0-F517-0E5E-25514B303A6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478903" y="3315998"/>
              <a:ext cx="548640" cy="548640"/>
            </a:xfrm>
            <a:prstGeom prst="ellipse">
              <a:avLst/>
            </a:prstGeom>
            <a:solidFill>
              <a:srgbClr val="FFFF00"/>
            </a:solidFill>
            <a:ln w="12700" algn="ctr">
              <a:solidFill>
                <a:srgbClr val="FF9933"/>
              </a:solidFill>
              <a:round/>
              <a:headEnd/>
              <a:tailEnd/>
            </a:ln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noFill/>
                </a:rPr>
                <a:t>Th0</a:t>
              </a:r>
            </a:p>
          </p:txBody>
        </p:sp>
        <p:grpSp>
          <p:nvGrpSpPr>
            <p:cNvPr id="6" name="Group 17">
              <a:extLst>
                <a:ext uri="{FF2B5EF4-FFF2-40B4-BE49-F238E27FC236}">
                  <a16:creationId xmlns:a16="http://schemas.microsoft.com/office/drawing/2014/main" id="{BFB1EA70-D273-6C57-A8AC-2A0175D1CDE5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5162169" y="3262747"/>
              <a:ext cx="959964" cy="914416"/>
              <a:chOff x="1333723" y="1766067"/>
              <a:chExt cx="1371600" cy="1306514"/>
            </a:xfrm>
          </p:grpSpPr>
          <p:sp>
            <p:nvSpPr>
              <p:cNvPr id="115" name="Oval 8">
                <a:extLst>
                  <a:ext uri="{FF2B5EF4-FFF2-40B4-BE49-F238E27FC236}">
                    <a16:creationId xmlns:a16="http://schemas.microsoft.com/office/drawing/2014/main" id="{D7BC93CF-02CC-38D1-C2FD-12D8908C98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3723" y="1766067"/>
                <a:ext cx="1371600" cy="1306514"/>
              </a:xfrm>
              <a:prstGeom prst="ellipse">
                <a:avLst/>
              </a:prstGeom>
              <a:solidFill>
                <a:srgbClr val="66FF33"/>
              </a:solidFill>
              <a:ln w="12700" algn="ctr">
                <a:solidFill>
                  <a:srgbClr val="FF9933"/>
                </a:solidFill>
                <a:round/>
                <a:headEnd/>
                <a:tailEnd/>
              </a:ln>
            </p:spPr>
            <p:txBody>
              <a:bodyPr anchor="ctr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2400"/>
              </a:p>
            </p:txBody>
          </p:sp>
          <p:sp>
            <p:nvSpPr>
              <p:cNvPr id="116" name="Oval 9">
                <a:extLst>
                  <a:ext uri="{FF2B5EF4-FFF2-40B4-BE49-F238E27FC236}">
                    <a16:creationId xmlns:a16="http://schemas.microsoft.com/office/drawing/2014/main" id="{804B6557-4CF7-E370-DC9D-D76995F529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6123" y="1983555"/>
                <a:ext cx="872836" cy="783335"/>
              </a:xfrm>
              <a:prstGeom prst="ellipse">
                <a:avLst/>
              </a:prstGeom>
              <a:solidFill>
                <a:srgbClr val="FFFF00"/>
              </a:solidFill>
              <a:ln w="12700" algn="ctr">
                <a:solidFill>
                  <a:srgbClr val="FF9933"/>
                </a:solidFill>
                <a:round/>
                <a:headEnd/>
                <a:tailEnd/>
              </a:ln>
            </p:spPr>
            <p:txBody>
              <a:bodyPr anchor="ctr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2400"/>
              </a:p>
            </p:txBody>
          </p:sp>
        </p:grpSp>
        <p:sp>
          <p:nvSpPr>
            <p:cNvPr id="7" name="Oval 8">
              <a:extLst>
                <a:ext uri="{FF2B5EF4-FFF2-40B4-BE49-F238E27FC236}">
                  <a16:creationId xmlns:a16="http://schemas.microsoft.com/office/drawing/2014/main" id="{F8E64FC3-B718-1CBA-9BE3-E816A3BD3B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14457" y="4772049"/>
              <a:ext cx="959964" cy="914416"/>
            </a:xfrm>
            <a:prstGeom prst="ellipse">
              <a:avLst/>
            </a:prstGeom>
            <a:solidFill>
              <a:srgbClr val="0070C0"/>
            </a:solidFill>
            <a:ln w="12700" algn="ctr">
              <a:solidFill>
                <a:srgbClr val="FF9933"/>
              </a:solidFill>
              <a:round/>
              <a:headEnd/>
              <a:tailEnd/>
            </a:ln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8" name="Oval 9">
              <a:extLst>
                <a:ext uri="{FF2B5EF4-FFF2-40B4-BE49-F238E27FC236}">
                  <a16:creationId xmlns:a16="http://schemas.microsoft.com/office/drawing/2014/main" id="{4681D245-A58C-3251-4941-820FAD1609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21120" y="4873799"/>
              <a:ext cx="610886" cy="649188"/>
            </a:xfrm>
            <a:prstGeom prst="ellipse">
              <a:avLst/>
            </a:prstGeom>
            <a:solidFill>
              <a:srgbClr val="FFFF00"/>
            </a:solidFill>
            <a:ln w="12700" algn="ctr">
              <a:solidFill>
                <a:srgbClr val="FF9933"/>
              </a:solidFill>
              <a:round/>
              <a:headEnd/>
              <a:tailEnd/>
            </a:ln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 b="1" dirty="0"/>
            </a:p>
          </p:txBody>
        </p:sp>
        <p:grpSp>
          <p:nvGrpSpPr>
            <p:cNvPr id="9" name="Group 29">
              <a:extLst>
                <a:ext uri="{FF2B5EF4-FFF2-40B4-BE49-F238E27FC236}">
                  <a16:creationId xmlns:a16="http://schemas.microsoft.com/office/drawing/2014/main" id="{5EA99A89-59DF-3290-9CE0-BB5E7229A958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3355957" y="4829744"/>
              <a:ext cx="959964" cy="914416"/>
              <a:chOff x="1333723" y="1766067"/>
              <a:chExt cx="1371600" cy="1306514"/>
            </a:xfrm>
          </p:grpSpPr>
          <p:sp>
            <p:nvSpPr>
              <p:cNvPr id="113" name="Oval 8">
                <a:extLst>
                  <a:ext uri="{FF2B5EF4-FFF2-40B4-BE49-F238E27FC236}">
                    <a16:creationId xmlns:a16="http://schemas.microsoft.com/office/drawing/2014/main" id="{BD0A6128-CAD8-C373-8A00-C64FBEEAA7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3723" y="1766067"/>
                <a:ext cx="1371600" cy="1306514"/>
              </a:xfrm>
              <a:prstGeom prst="ellipse">
                <a:avLst/>
              </a:prstGeom>
              <a:solidFill>
                <a:srgbClr val="66FF33"/>
              </a:solidFill>
              <a:ln w="12700" algn="ctr">
                <a:solidFill>
                  <a:srgbClr val="FF9933"/>
                </a:solidFill>
                <a:round/>
                <a:headEnd/>
                <a:tailEnd/>
              </a:ln>
            </p:spPr>
            <p:txBody>
              <a:bodyPr anchor="ctr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2400"/>
              </a:p>
            </p:txBody>
          </p:sp>
          <p:sp>
            <p:nvSpPr>
              <p:cNvPr id="114" name="Oval 9">
                <a:extLst>
                  <a:ext uri="{FF2B5EF4-FFF2-40B4-BE49-F238E27FC236}">
                    <a16:creationId xmlns:a16="http://schemas.microsoft.com/office/drawing/2014/main" id="{0BADC7B5-234E-C0B6-A6DA-E44DFA8C61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6123" y="1983555"/>
                <a:ext cx="872836" cy="783335"/>
              </a:xfrm>
              <a:prstGeom prst="ellipse">
                <a:avLst/>
              </a:prstGeom>
              <a:solidFill>
                <a:srgbClr val="FFFF00"/>
              </a:solidFill>
              <a:ln w="12700" algn="ctr">
                <a:solidFill>
                  <a:srgbClr val="FF9933"/>
                </a:solidFill>
                <a:round/>
                <a:headEnd/>
                <a:tailEnd/>
              </a:ln>
            </p:spPr>
            <p:txBody>
              <a:bodyPr anchor="ctr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2400"/>
              </a:p>
            </p:txBody>
          </p:sp>
        </p:grpSp>
        <p:grpSp>
          <p:nvGrpSpPr>
            <p:cNvPr id="10" name="Group 41">
              <a:extLst>
                <a:ext uri="{FF2B5EF4-FFF2-40B4-BE49-F238E27FC236}">
                  <a16:creationId xmlns:a16="http://schemas.microsoft.com/office/drawing/2014/main" id="{8C78CED3-E529-D9E6-C174-42F1C6CCCAD5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1345674" y="3206406"/>
              <a:ext cx="1415124" cy="1188741"/>
              <a:chOff x="7245862" y="1356186"/>
              <a:chExt cx="2358513" cy="1981201"/>
            </a:xfrm>
          </p:grpSpPr>
          <p:sp>
            <p:nvSpPr>
              <p:cNvPr id="111" name="Freeform 10">
                <a:extLst>
                  <a:ext uri="{FF2B5EF4-FFF2-40B4-BE49-F238E27FC236}">
                    <a16:creationId xmlns:a16="http://schemas.microsoft.com/office/drawing/2014/main" id="{58539557-87EA-0796-8BF9-AE290DF88C7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45862" y="1356186"/>
                <a:ext cx="2358513" cy="1981201"/>
              </a:xfrm>
              <a:custGeom>
                <a:avLst/>
                <a:gdLst>
                  <a:gd name="T0" fmla="*/ 2147483646 w 904"/>
                  <a:gd name="T1" fmla="*/ 2147483646 h 792"/>
                  <a:gd name="T2" fmla="*/ 2147483646 w 904"/>
                  <a:gd name="T3" fmla="*/ 2147483646 h 792"/>
                  <a:gd name="T4" fmla="*/ 2147483646 w 904"/>
                  <a:gd name="T5" fmla="*/ 2147483646 h 792"/>
                  <a:gd name="T6" fmla="*/ 2147483646 w 904"/>
                  <a:gd name="T7" fmla="*/ 2147483646 h 792"/>
                  <a:gd name="T8" fmla="*/ 2147483646 w 904"/>
                  <a:gd name="T9" fmla="*/ 2147483646 h 792"/>
                  <a:gd name="T10" fmla="*/ 2147483646 w 904"/>
                  <a:gd name="T11" fmla="*/ 2147483646 h 792"/>
                  <a:gd name="T12" fmla="*/ 2147483646 w 904"/>
                  <a:gd name="T13" fmla="*/ 2147483646 h 792"/>
                  <a:gd name="T14" fmla="*/ 2147483646 w 904"/>
                  <a:gd name="T15" fmla="*/ 2147483646 h 792"/>
                  <a:gd name="T16" fmla="*/ 2147483646 w 904"/>
                  <a:gd name="T17" fmla="*/ 2147483646 h 792"/>
                  <a:gd name="T18" fmla="*/ 2147483646 w 904"/>
                  <a:gd name="T19" fmla="*/ 2147483646 h 792"/>
                  <a:gd name="T20" fmla="*/ 2147483646 w 904"/>
                  <a:gd name="T21" fmla="*/ 2147483646 h 792"/>
                  <a:gd name="T22" fmla="*/ 2147483646 w 904"/>
                  <a:gd name="T23" fmla="*/ 2147483646 h 792"/>
                  <a:gd name="T24" fmla="*/ 2147483646 w 904"/>
                  <a:gd name="T25" fmla="*/ 2147483646 h 792"/>
                  <a:gd name="T26" fmla="*/ 2147483646 w 904"/>
                  <a:gd name="T27" fmla="*/ 2147483646 h 792"/>
                  <a:gd name="T28" fmla="*/ 2147483646 w 904"/>
                  <a:gd name="T29" fmla="*/ 2147483646 h 792"/>
                  <a:gd name="T30" fmla="*/ 2147483646 w 904"/>
                  <a:gd name="T31" fmla="*/ 2147483646 h 792"/>
                  <a:gd name="T32" fmla="*/ 2147483646 w 904"/>
                  <a:gd name="T33" fmla="*/ 2147483646 h 792"/>
                  <a:gd name="T34" fmla="*/ 2147483646 w 904"/>
                  <a:gd name="T35" fmla="*/ 2147483646 h 792"/>
                  <a:gd name="T36" fmla="*/ 2147483646 w 904"/>
                  <a:gd name="T37" fmla="*/ 2147483646 h 792"/>
                  <a:gd name="T38" fmla="*/ 2147483646 w 904"/>
                  <a:gd name="T39" fmla="*/ 2147483646 h 792"/>
                  <a:gd name="T40" fmla="*/ 2147483646 w 904"/>
                  <a:gd name="T41" fmla="*/ 2147483646 h 792"/>
                  <a:gd name="T42" fmla="*/ 2147483646 w 904"/>
                  <a:gd name="T43" fmla="*/ 2147483646 h 792"/>
                  <a:gd name="T44" fmla="*/ 2147483646 w 904"/>
                  <a:gd name="T45" fmla="*/ 2147483646 h 792"/>
                  <a:gd name="T46" fmla="*/ 2147483646 w 904"/>
                  <a:gd name="T47" fmla="*/ 2147483646 h 792"/>
                  <a:gd name="T48" fmla="*/ 2147483646 w 904"/>
                  <a:gd name="T49" fmla="*/ 2147483646 h 792"/>
                  <a:gd name="T50" fmla="*/ 2147483646 w 904"/>
                  <a:gd name="T51" fmla="*/ 2147483646 h 792"/>
                  <a:gd name="T52" fmla="*/ 2147483646 w 904"/>
                  <a:gd name="T53" fmla="*/ 2147483646 h 792"/>
                  <a:gd name="T54" fmla="*/ 2147483646 w 904"/>
                  <a:gd name="T55" fmla="*/ 2147483646 h 792"/>
                  <a:gd name="T56" fmla="*/ 2147483646 w 904"/>
                  <a:gd name="T57" fmla="*/ 2147483646 h 792"/>
                  <a:gd name="T58" fmla="*/ 2147483646 w 904"/>
                  <a:gd name="T59" fmla="*/ 2147483646 h 792"/>
                  <a:gd name="T60" fmla="*/ 2147483646 w 904"/>
                  <a:gd name="T61" fmla="*/ 2147483646 h 792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  <a:gd name="T69" fmla="*/ 0 60000 65536"/>
                  <a:gd name="T70" fmla="*/ 0 60000 65536"/>
                  <a:gd name="T71" fmla="*/ 0 60000 65536"/>
                  <a:gd name="T72" fmla="*/ 0 60000 65536"/>
                  <a:gd name="T73" fmla="*/ 0 60000 65536"/>
                  <a:gd name="T74" fmla="*/ 0 60000 65536"/>
                  <a:gd name="T75" fmla="*/ 0 60000 65536"/>
                  <a:gd name="T76" fmla="*/ 0 60000 65536"/>
                  <a:gd name="T77" fmla="*/ 0 60000 65536"/>
                  <a:gd name="T78" fmla="*/ 0 60000 65536"/>
                  <a:gd name="T79" fmla="*/ 0 60000 65536"/>
                  <a:gd name="T80" fmla="*/ 0 60000 65536"/>
                  <a:gd name="T81" fmla="*/ 0 60000 65536"/>
                  <a:gd name="T82" fmla="*/ 0 60000 65536"/>
                  <a:gd name="T83" fmla="*/ 0 60000 65536"/>
                  <a:gd name="T84" fmla="*/ 0 60000 65536"/>
                  <a:gd name="T85" fmla="*/ 0 60000 65536"/>
                  <a:gd name="T86" fmla="*/ 0 60000 65536"/>
                  <a:gd name="T87" fmla="*/ 0 60000 65536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w 904"/>
                  <a:gd name="T94" fmla="*/ 0 h 792"/>
                  <a:gd name="T95" fmla="*/ 904 w 904"/>
                  <a:gd name="T96" fmla="*/ 792 h 792"/>
                </a:gdLst>
                <a:ahLst/>
                <a:cxnLst>
                  <a:cxn ang="T62">
                    <a:pos x="T0" y="T1"/>
                  </a:cxn>
                  <a:cxn ang="T63">
                    <a:pos x="T2" y="T3"/>
                  </a:cxn>
                  <a:cxn ang="T64">
                    <a:pos x="T4" y="T5"/>
                  </a:cxn>
                  <a:cxn ang="T65">
                    <a:pos x="T6" y="T7"/>
                  </a:cxn>
                  <a:cxn ang="T66">
                    <a:pos x="T8" y="T9"/>
                  </a:cxn>
                  <a:cxn ang="T67">
                    <a:pos x="T10" y="T11"/>
                  </a:cxn>
                  <a:cxn ang="T68">
                    <a:pos x="T12" y="T13"/>
                  </a:cxn>
                  <a:cxn ang="T69">
                    <a:pos x="T14" y="T15"/>
                  </a:cxn>
                  <a:cxn ang="T70">
                    <a:pos x="T16" y="T17"/>
                  </a:cxn>
                  <a:cxn ang="T71">
                    <a:pos x="T18" y="T19"/>
                  </a:cxn>
                  <a:cxn ang="T72">
                    <a:pos x="T20" y="T21"/>
                  </a:cxn>
                  <a:cxn ang="T73">
                    <a:pos x="T22" y="T23"/>
                  </a:cxn>
                  <a:cxn ang="T74">
                    <a:pos x="T24" y="T25"/>
                  </a:cxn>
                  <a:cxn ang="T75">
                    <a:pos x="T26" y="T27"/>
                  </a:cxn>
                  <a:cxn ang="T76">
                    <a:pos x="T28" y="T29"/>
                  </a:cxn>
                  <a:cxn ang="T77">
                    <a:pos x="T30" y="T31"/>
                  </a:cxn>
                  <a:cxn ang="T78">
                    <a:pos x="T32" y="T33"/>
                  </a:cxn>
                  <a:cxn ang="T79">
                    <a:pos x="T34" y="T35"/>
                  </a:cxn>
                  <a:cxn ang="T80">
                    <a:pos x="T36" y="T37"/>
                  </a:cxn>
                  <a:cxn ang="T81">
                    <a:pos x="T38" y="T39"/>
                  </a:cxn>
                  <a:cxn ang="T82">
                    <a:pos x="T40" y="T41"/>
                  </a:cxn>
                  <a:cxn ang="T83">
                    <a:pos x="T42" y="T43"/>
                  </a:cxn>
                  <a:cxn ang="T84">
                    <a:pos x="T44" y="T45"/>
                  </a:cxn>
                  <a:cxn ang="T85">
                    <a:pos x="T46" y="T47"/>
                  </a:cxn>
                  <a:cxn ang="T86">
                    <a:pos x="T48" y="T49"/>
                  </a:cxn>
                  <a:cxn ang="T87">
                    <a:pos x="T50" y="T51"/>
                  </a:cxn>
                  <a:cxn ang="T88">
                    <a:pos x="T52" y="T53"/>
                  </a:cxn>
                  <a:cxn ang="T89">
                    <a:pos x="T54" y="T55"/>
                  </a:cxn>
                  <a:cxn ang="T90">
                    <a:pos x="T56" y="T57"/>
                  </a:cxn>
                  <a:cxn ang="T91">
                    <a:pos x="T58" y="T59"/>
                  </a:cxn>
                  <a:cxn ang="T92">
                    <a:pos x="T60" y="T61"/>
                  </a:cxn>
                </a:cxnLst>
                <a:rect l="T93" t="T94" r="T95" b="T96"/>
                <a:pathLst>
                  <a:path w="904" h="792">
                    <a:moveTo>
                      <a:pt x="360" y="304"/>
                    </a:moveTo>
                    <a:cubicBezTo>
                      <a:pt x="392" y="304"/>
                      <a:pt x="368" y="208"/>
                      <a:pt x="360" y="160"/>
                    </a:cubicBezTo>
                    <a:cubicBezTo>
                      <a:pt x="352" y="112"/>
                      <a:pt x="304" y="32"/>
                      <a:pt x="312" y="16"/>
                    </a:cubicBezTo>
                    <a:cubicBezTo>
                      <a:pt x="320" y="0"/>
                      <a:pt x="384" y="32"/>
                      <a:pt x="408" y="64"/>
                    </a:cubicBezTo>
                    <a:cubicBezTo>
                      <a:pt x="432" y="96"/>
                      <a:pt x="448" y="168"/>
                      <a:pt x="456" y="208"/>
                    </a:cubicBezTo>
                    <a:cubicBezTo>
                      <a:pt x="464" y="248"/>
                      <a:pt x="448" y="296"/>
                      <a:pt x="456" y="304"/>
                    </a:cubicBezTo>
                    <a:cubicBezTo>
                      <a:pt x="464" y="312"/>
                      <a:pt x="488" y="288"/>
                      <a:pt x="504" y="256"/>
                    </a:cubicBezTo>
                    <a:cubicBezTo>
                      <a:pt x="520" y="224"/>
                      <a:pt x="536" y="144"/>
                      <a:pt x="552" y="112"/>
                    </a:cubicBezTo>
                    <a:cubicBezTo>
                      <a:pt x="568" y="80"/>
                      <a:pt x="584" y="40"/>
                      <a:pt x="600" y="64"/>
                    </a:cubicBezTo>
                    <a:cubicBezTo>
                      <a:pt x="616" y="88"/>
                      <a:pt x="656" y="208"/>
                      <a:pt x="648" y="256"/>
                    </a:cubicBezTo>
                    <a:cubicBezTo>
                      <a:pt x="640" y="304"/>
                      <a:pt x="560" y="328"/>
                      <a:pt x="552" y="352"/>
                    </a:cubicBezTo>
                    <a:cubicBezTo>
                      <a:pt x="544" y="376"/>
                      <a:pt x="568" y="400"/>
                      <a:pt x="600" y="400"/>
                    </a:cubicBezTo>
                    <a:cubicBezTo>
                      <a:pt x="632" y="400"/>
                      <a:pt x="712" y="376"/>
                      <a:pt x="744" y="352"/>
                    </a:cubicBezTo>
                    <a:cubicBezTo>
                      <a:pt x="776" y="328"/>
                      <a:pt x="768" y="256"/>
                      <a:pt x="792" y="256"/>
                    </a:cubicBezTo>
                    <a:cubicBezTo>
                      <a:pt x="816" y="256"/>
                      <a:pt x="904" y="312"/>
                      <a:pt x="888" y="352"/>
                    </a:cubicBezTo>
                    <a:cubicBezTo>
                      <a:pt x="872" y="392"/>
                      <a:pt x="752" y="472"/>
                      <a:pt x="696" y="496"/>
                    </a:cubicBezTo>
                    <a:cubicBezTo>
                      <a:pt x="640" y="520"/>
                      <a:pt x="552" y="472"/>
                      <a:pt x="552" y="496"/>
                    </a:cubicBezTo>
                    <a:cubicBezTo>
                      <a:pt x="552" y="520"/>
                      <a:pt x="672" y="592"/>
                      <a:pt x="696" y="640"/>
                    </a:cubicBezTo>
                    <a:cubicBezTo>
                      <a:pt x="720" y="688"/>
                      <a:pt x="704" y="776"/>
                      <a:pt x="696" y="784"/>
                    </a:cubicBezTo>
                    <a:cubicBezTo>
                      <a:pt x="688" y="792"/>
                      <a:pt x="688" y="728"/>
                      <a:pt x="648" y="688"/>
                    </a:cubicBezTo>
                    <a:cubicBezTo>
                      <a:pt x="608" y="648"/>
                      <a:pt x="496" y="544"/>
                      <a:pt x="456" y="544"/>
                    </a:cubicBezTo>
                    <a:cubicBezTo>
                      <a:pt x="416" y="544"/>
                      <a:pt x="416" y="648"/>
                      <a:pt x="408" y="688"/>
                    </a:cubicBezTo>
                    <a:cubicBezTo>
                      <a:pt x="400" y="728"/>
                      <a:pt x="432" y="784"/>
                      <a:pt x="408" y="784"/>
                    </a:cubicBezTo>
                    <a:cubicBezTo>
                      <a:pt x="384" y="784"/>
                      <a:pt x="272" y="728"/>
                      <a:pt x="264" y="688"/>
                    </a:cubicBezTo>
                    <a:cubicBezTo>
                      <a:pt x="256" y="648"/>
                      <a:pt x="384" y="568"/>
                      <a:pt x="360" y="544"/>
                    </a:cubicBezTo>
                    <a:cubicBezTo>
                      <a:pt x="336" y="520"/>
                      <a:pt x="176" y="560"/>
                      <a:pt x="120" y="544"/>
                    </a:cubicBezTo>
                    <a:cubicBezTo>
                      <a:pt x="64" y="528"/>
                      <a:pt x="0" y="472"/>
                      <a:pt x="24" y="448"/>
                    </a:cubicBezTo>
                    <a:cubicBezTo>
                      <a:pt x="48" y="424"/>
                      <a:pt x="256" y="440"/>
                      <a:pt x="264" y="400"/>
                    </a:cubicBezTo>
                    <a:cubicBezTo>
                      <a:pt x="272" y="360"/>
                      <a:pt x="88" y="248"/>
                      <a:pt x="72" y="208"/>
                    </a:cubicBezTo>
                    <a:cubicBezTo>
                      <a:pt x="56" y="168"/>
                      <a:pt x="120" y="144"/>
                      <a:pt x="168" y="160"/>
                    </a:cubicBezTo>
                    <a:cubicBezTo>
                      <a:pt x="216" y="176"/>
                      <a:pt x="328" y="304"/>
                      <a:pt x="360" y="304"/>
                    </a:cubicBezTo>
                    <a:close/>
                  </a:path>
                </a:pathLst>
              </a:custGeom>
              <a:solidFill>
                <a:srgbClr val="00FFFF"/>
              </a:solidFill>
              <a:ln w="12700" cap="flat" cmpd="sng">
                <a:solidFill>
                  <a:srgbClr val="FF9933"/>
                </a:solidFill>
                <a:prstDash val="solid"/>
                <a:round/>
                <a:headEnd/>
                <a:tailEnd/>
              </a:ln>
            </p:spPr>
            <p:txBody>
              <a:bodyPr>
                <a:spAutoFit/>
              </a:bodyPr>
              <a:lstStyle/>
              <a:p>
                <a:endParaRPr lang="en-US"/>
              </a:p>
            </p:txBody>
          </p:sp>
          <p:sp>
            <p:nvSpPr>
              <p:cNvPr id="112" name="Freeform 11">
                <a:extLst>
                  <a:ext uri="{FF2B5EF4-FFF2-40B4-BE49-F238E27FC236}">
                    <a16:creationId xmlns:a16="http://schemas.microsoft.com/office/drawing/2014/main" id="{C38D0F16-74F2-FFD8-D026-1EBFD8A62F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95544" y="2226136"/>
                <a:ext cx="459148" cy="358289"/>
              </a:xfrm>
              <a:custGeom>
                <a:avLst/>
                <a:gdLst>
                  <a:gd name="T0" fmla="*/ 2147483646 w 184"/>
                  <a:gd name="T1" fmla="*/ 2147483646 h 160"/>
                  <a:gd name="T2" fmla="*/ 2147483646 w 184"/>
                  <a:gd name="T3" fmla="*/ 2147483646 h 160"/>
                  <a:gd name="T4" fmla="*/ 2147483646 w 184"/>
                  <a:gd name="T5" fmla="*/ 2147483646 h 160"/>
                  <a:gd name="T6" fmla="*/ 2147483646 w 184"/>
                  <a:gd name="T7" fmla="*/ 2147483646 h 160"/>
                  <a:gd name="T8" fmla="*/ 2147483646 w 184"/>
                  <a:gd name="T9" fmla="*/ 2147483646 h 160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84"/>
                  <a:gd name="T16" fmla="*/ 0 h 160"/>
                  <a:gd name="T17" fmla="*/ 184 w 184"/>
                  <a:gd name="T18" fmla="*/ 160 h 160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84" h="160">
                    <a:moveTo>
                      <a:pt x="24" y="56"/>
                    </a:moveTo>
                    <a:cubicBezTo>
                      <a:pt x="40" y="32"/>
                      <a:pt x="96" y="0"/>
                      <a:pt x="120" y="8"/>
                    </a:cubicBezTo>
                    <a:cubicBezTo>
                      <a:pt x="144" y="16"/>
                      <a:pt x="184" y="80"/>
                      <a:pt x="168" y="104"/>
                    </a:cubicBezTo>
                    <a:cubicBezTo>
                      <a:pt x="152" y="128"/>
                      <a:pt x="48" y="160"/>
                      <a:pt x="24" y="152"/>
                    </a:cubicBezTo>
                    <a:cubicBezTo>
                      <a:pt x="0" y="144"/>
                      <a:pt x="8" y="80"/>
                      <a:pt x="24" y="56"/>
                    </a:cubicBezTo>
                    <a:close/>
                  </a:path>
                </a:pathLst>
              </a:custGeom>
              <a:solidFill>
                <a:srgbClr val="FFFF00"/>
              </a:solidFill>
              <a:ln w="12700" cap="flat" cmpd="sng">
                <a:solidFill>
                  <a:srgbClr val="FF9933"/>
                </a:solidFill>
                <a:prstDash val="solid"/>
                <a:round/>
                <a:headEnd/>
                <a:tailEnd/>
              </a:ln>
            </p:spPr>
            <p:txBody>
              <a:bodyPr>
                <a:spAutoFit/>
              </a:bodyPr>
              <a:lstStyle/>
              <a:p>
                <a:endParaRPr lang="en-US"/>
              </a:p>
            </p:txBody>
          </p:sp>
        </p:grpSp>
        <p:sp>
          <p:nvSpPr>
            <p:cNvPr id="11" name="Rounded Rectangle 44">
              <a:extLst>
                <a:ext uri="{FF2B5EF4-FFF2-40B4-BE49-F238E27FC236}">
                  <a16:creationId xmlns:a16="http://schemas.microsoft.com/office/drawing/2014/main" id="{50AAFAC8-9458-B940-D896-B51AE4B3FFD9}"/>
                </a:ext>
              </a:extLst>
            </p:cNvPr>
            <p:cNvSpPr/>
            <p:nvPr/>
          </p:nvSpPr>
          <p:spPr bwMode="auto">
            <a:xfrm rot="10800000">
              <a:off x="2332642" y="3348659"/>
              <a:ext cx="401637" cy="44450"/>
            </a:xfrm>
            <a:prstGeom prst="roundRect">
              <a:avLst/>
            </a:prstGeom>
            <a:solidFill>
              <a:srgbClr val="FFC000"/>
            </a:solidFill>
            <a:ln w="3175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2" name="Rounded Rectangle 45">
              <a:extLst>
                <a:ext uri="{FF2B5EF4-FFF2-40B4-BE49-F238E27FC236}">
                  <a16:creationId xmlns:a16="http://schemas.microsoft.com/office/drawing/2014/main" id="{5F65762A-D9B5-DF98-BC97-ACB7B97DA3D9}"/>
                </a:ext>
              </a:extLst>
            </p:cNvPr>
            <p:cNvSpPr/>
            <p:nvPr/>
          </p:nvSpPr>
          <p:spPr bwMode="auto">
            <a:xfrm>
              <a:off x="2332642" y="3389934"/>
              <a:ext cx="401637" cy="44450"/>
            </a:xfrm>
            <a:prstGeom prst="roundRect">
              <a:avLst/>
            </a:prstGeom>
            <a:solidFill>
              <a:srgbClr val="FFC000"/>
            </a:solidFill>
            <a:ln w="3175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3" name="Flowchart: Stored Data 12">
              <a:extLst>
                <a:ext uri="{FF2B5EF4-FFF2-40B4-BE49-F238E27FC236}">
                  <a16:creationId xmlns:a16="http://schemas.microsoft.com/office/drawing/2014/main" id="{DDAF69D5-BD5B-F41E-2E22-BF39FDE32473}"/>
                </a:ext>
              </a:extLst>
            </p:cNvPr>
            <p:cNvSpPr/>
            <p:nvPr/>
          </p:nvSpPr>
          <p:spPr bwMode="auto">
            <a:xfrm rot="10800000">
              <a:off x="2947004" y="3341015"/>
              <a:ext cx="460375" cy="87312"/>
            </a:xfrm>
            <a:prstGeom prst="flowChartOnlineStorage">
              <a:avLst/>
            </a:prstGeom>
            <a:solidFill>
              <a:srgbClr val="33794F"/>
            </a:solidFill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schemeClr val="accent1">
                    <a:lumMod val="75000"/>
                  </a:schemeClr>
                </a:solidFill>
              </a:endParaRPr>
            </a:p>
          </p:txBody>
        </p:sp>
        <p:sp>
          <p:nvSpPr>
            <p:cNvPr id="14" name="Pie 47">
              <a:extLst>
                <a:ext uri="{FF2B5EF4-FFF2-40B4-BE49-F238E27FC236}">
                  <a16:creationId xmlns:a16="http://schemas.microsoft.com/office/drawing/2014/main" id="{CB9DA028-B114-A969-AD2B-854DE7DC1F98}"/>
                </a:ext>
              </a:extLst>
            </p:cNvPr>
            <p:cNvSpPr/>
            <p:nvPr/>
          </p:nvSpPr>
          <p:spPr bwMode="auto">
            <a:xfrm rot="10800000">
              <a:off x="2783492" y="3545509"/>
              <a:ext cx="585787" cy="87313"/>
            </a:xfrm>
            <a:prstGeom prst="pie">
              <a:avLst/>
            </a:prstGeom>
            <a:solidFill>
              <a:srgbClr val="2222EA"/>
            </a:solidFill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5" name="Teardrop 14">
              <a:extLst>
                <a:ext uri="{FF2B5EF4-FFF2-40B4-BE49-F238E27FC236}">
                  <a16:creationId xmlns:a16="http://schemas.microsoft.com/office/drawing/2014/main" id="{4D329C77-CE8F-5753-EA09-4D073740B484}"/>
                </a:ext>
              </a:extLst>
            </p:cNvPr>
            <p:cNvSpPr/>
            <p:nvPr/>
          </p:nvSpPr>
          <p:spPr bwMode="auto">
            <a:xfrm>
              <a:off x="2361217" y="3577259"/>
              <a:ext cx="585787" cy="46038"/>
            </a:xfrm>
            <a:prstGeom prst="teardrop">
              <a:avLst/>
            </a:prstGeom>
            <a:solidFill>
              <a:srgbClr val="DB31CF"/>
            </a:solidFill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6" name="TextBox 49">
              <a:extLst>
                <a:ext uri="{FF2B5EF4-FFF2-40B4-BE49-F238E27FC236}">
                  <a16:creationId xmlns:a16="http://schemas.microsoft.com/office/drawing/2014/main" id="{2068BD5A-B300-BE0C-FB14-D3289DD383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42987" y="3180837"/>
              <a:ext cx="417106" cy="2154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800" b="1" dirty="0">
                  <a:cs typeface="Arial" panose="020B0604020202020204" pitchFamily="34" charset="0"/>
                </a:rPr>
                <a:t>MHC</a:t>
              </a:r>
            </a:p>
          </p:txBody>
        </p:sp>
        <p:sp>
          <p:nvSpPr>
            <p:cNvPr id="17" name="TextBox 50">
              <a:extLst>
                <a:ext uri="{FF2B5EF4-FFF2-40B4-BE49-F238E27FC236}">
                  <a16:creationId xmlns:a16="http://schemas.microsoft.com/office/drawing/2014/main" id="{4483DC95-F76C-9E00-5C97-9FFC992529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86277" y="3385189"/>
              <a:ext cx="394664" cy="2154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800" b="1" dirty="0">
                  <a:cs typeface="Arial" panose="020B0604020202020204" pitchFamily="34" charset="0"/>
                </a:rPr>
                <a:t>TCR</a:t>
              </a:r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69A9FBD6-EC85-B63E-F451-4D6273D65BF7}"/>
                </a:ext>
              </a:extLst>
            </p:cNvPr>
            <p:cNvSpPr/>
            <p:nvPr/>
          </p:nvSpPr>
          <p:spPr bwMode="auto">
            <a:xfrm rot="10800000">
              <a:off x="2918429" y="3302622"/>
              <a:ext cx="249238" cy="4445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9" name="TextBox 52">
              <a:extLst>
                <a:ext uri="{FF2B5EF4-FFF2-40B4-BE49-F238E27FC236}">
                  <a16:creationId xmlns:a16="http://schemas.microsoft.com/office/drawing/2014/main" id="{77BC2704-8CCA-1D7E-F485-193155A3FE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65372" y="3623086"/>
              <a:ext cx="447563" cy="2154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800" b="1" dirty="0">
                  <a:cs typeface="Arial" panose="020B0604020202020204" pitchFamily="34" charset="0"/>
                </a:rPr>
                <a:t>CD28</a:t>
              </a:r>
            </a:p>
          </p:txBody>
        </p:sp>
        <p:sp>
          <p:nvSpPr>
            <p:cNvPr id="20" name="TextBox 53">
              <a:extLst>
                <a:ext uri="{FF2B5EF4-FFF2-40B4-BE49-F238E27FC236}">
                  <a16:creationId xmlns:a16="http://schemas.microsoft.com/office/drawing/2014/main" id="{1232EC8D-DE21-CB13-9835-71BA60893C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74970" y="3623086"/>
              <a:ext cx="3161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800" b="1">
                  <a:cs typeface="Arial" panose="020B0604020202020204" pitchFamily="34" charset="0"/>
                </a:rPr>
                <a:t>B7</a:t>
              </a:r>
            </a:p>
          </p:txBody>
        </p:sp>
        <p:sp>
          <p:nvSpPr>
            <p:cNvPr id="21" name="TextBox 54">
              <a:extLst>
                <a:ext uri="{FF2B5EF4-FFF2-40B4-BE49-F238E27FC236}">
                  <a16:creationId xmlns:a16="http://schemas.microsoft.com/office/drawing/2014/main" id="{DFD4F751-1BD6-1482-4884-3B7A0B190A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18880" y="3116247"/>
              <a:ext cx="389854" cy="2154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800" b="1" dirty="0"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2" name="TextBox 87">
              <a:extLst>
                <a:ext uri="{FF2B5EF4-FFF2-40B4-BE49-F238E27FC236}">
                  <a16:creationId xmlns:a16="http://schemas.microsoft.com/office/drawing/2014/main" id="{FA36FD6A-8A76-D54D-409C-0985B2AF23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60112" y="3542237"/>
              <a:ext cx="43633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/>
                <a:t>Th2</a:t>
              </a:r>
            </a:p>
          </p:txBody>
        </p:sp>
        <p:sp>
          <p:nvSpPr>
            <p:cNvPr id="23" name="TextBox 88">
              <a:extLst>
                <a:ext uri="{FF2B5EF4-FFF2-40B4-BE49-F238E27FC236}">
                  <a16:creationId xmlns:a16="http://schemas.microsoft.com/office/drawing/2014/main" id="{A8DB900C-CD57-D3C3-D526-E528EE95D5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768443" y="5070798"/>
              <a:ext cx="55976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/>
                <a:t>B cell</a:t>
              </a:r>
            </a:p>
          </p:txBody>
        </p:sp>
        <p:sp>
          <p:nvSpPr>
            <p:cNvPr id="24" name="TextBox 90">
              <a:extLst>
                <a:ext uri="{FF2B5EF4-FFF2-40B4-BE49-F238E27FC236}">
                  <a16:creationId xmlns:a16="http://schemas.microsoft.com/office/drawing/2014/main" id="{82BDE30D-DD0A-3452-520F-ABC96AA943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30656" y="5125279"/>
              <a:ext cx="49084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/>
                <a:t>Treg</a:t>
              </a:r>
            </a:p>
          </p:txBody>
        </p:sp>
        <p:grpSp>
          <p:nvGrpSpPr>
            <p:cNvPr id="25" name="Group 91">
              <a:extLst>
                <a:ext uri="{FF2B5EF4-FFF2-40B4-BE49-F238E27FC236}">
                  <a16:creationId xmlns:a16="http://schemas.microsoft.com/office/drawing/2014/main" id="{F3153FB4-878B-E1B4-AD0E-17236B26FB3E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5201998" y="4811794"/>
              <a:ext cx="959964" cy="914416"/>
              <a:chOff x="1333723" y="1766067"/>
              <a:chExt cx="1371600" cy="1306514"/>
            </a:xfrm>
          </p:grpSpPr>
          <p:sp>
            <p:nvSpPr>
              <p:cNvPr id="109" name="Oval 8">
                <a:extLst>
                  <a:ext uri="{FF2B5EF4-FFF2-40B4-BE49-F238E27FC236}">
                    <a16:creationId xmlns:a16="http://schemas.microsoft.com/office/drawing/2014/main" id="{6D94B0FE-8325-BF89-B7BD-900A20F8E6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3723" y="1766067"/>
                <a:ext cx="1371600" cy="1306514"/>
              </a:xfrm>
              <a:prstGeom prst="ellipse">
                <a:avLst/>
              </a:prstGeom>
              <a:solidFill>
                <a:srgbClr val="66FF33"/>
              </a:solidFill>
              <a:ln w="12700" algn="ctr">
                <a:solidFill>
                  <a:srgbClr val="FF9933"/>
                </a:solidFill>
                <a:round/>
                <a:headEnd/>
                <a:tailEnd/>
              </a:ln>
            </p:spPr>
            <p:txBody>
              <a:bodyPr anchor="ctr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2400"/>
              </a:p>
            </p:txBody>
          </p:sp>
          <p:sp>
            <p:nvSpPr>
              <p:cNvPr id="110" name="Oval 9">
                <a:extLst>
                  <a:ext uri="{FF2B5EF4-FFF2-40B4-BE49-F238E27FC236}">
                    <a16:creationId xmlns:a16="http://schemas.microsoft.com/office/drawing/2014/main" id="{440B0A76-4923-BD4D-8914-80D1527C4C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6123" y="1983555"/>
                <a:ext cx="872836" cy="783335"/>
              </a:xfrm>
              <a:prstGeom prst="ellipse">
                <a:avLst/>
              </a:prstGeom>
              <a:solidFill>
                <a:srgbClr val="FFFF00"/>
              </a:solidFill>
              <a:ln w="12700" algn="ctr">
                <a:solidFill>
                  <a:srgbClr val="FF9933"/>
                </a:solidFill>
                <a:round/>
                <a:headEnd/>
                <a:tailEnd/>
              </a:ln>
            </p:spPr>
            <p:txBody>
              <a:bodyPr anchor="ctr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2400"/>
              </a:p>
            </p:txBody>
          </p:sp>
        </p:grpSp>
        <p:sp>
          <p:nvSpPr>
            <p:cNvPr id="26" name="TextBox 94">
              <a:extLst>
                <a:ext uri="{FF2B5EF4-FFF2-40B4-BE49-F238E27FC236}">
                  <a16:creationId xmlns:a16="http://schemas.microsoft.com/office/drawing/2014/main" id="{0F6D17E6-5AA2-4CC4-78C5-0C9C2C21042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19978" y="5149195"/>
              <a:ext cx="40427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/>
                <a:t>Tfh</a:t>
              </a:r>
            </a:p>
          </p:txBody>
        </p:sp>
        <p:pic>
          <p:nvPicPr>
            <p:cNvPr id="27" name="Picture 97">
              <a:extLst>
                <a:ext uri="{FF2B5EF4-FFF2-40B4-BE49-F238E27FC236}">
                  <a16:creationId xmlns:a16="http://schemas.microsoft.com/office/drawing/2014/main" id="{B1975C90-E329-806C-E015-0BF94780454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97343" y="1633826"/>
              <a:ext cx="1219213" cy="9144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TextBox 102">
              <a:extLst>
                <a:ext uri="{FF2B5EF4-FFF2-40B4-BE49-F238E27FC236}">
                  <a16:creationId xmlns:a16="http://schemas.microsoft.com/office/drawing/2014/main" id="{53F63E56-269E-DA3F-63CD-F97098C7F3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29334" y="2548242"/>
              <a:ext cx="74892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/>
                <a:t>Allergen</a:t>
              </a:r>
            </a:p>
          </p:txBody>
        </p:sp>
        <p:sp>
          <p:nvSpPr>
            <p:cNvPr id="29" name="Oval 107">
              <a:extLst>
                <a:ext uri="{FF2B5EF4-FFF2-40B4-BE49-F238E27FC236}">
                  <a16:creationId xmlns:a16="http://schemas.microsoft.com/office/drawing/2014/main" id="{671B729D-1695-A8BA-8308-E19FB8E380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7947" y="3333575"/>
              <a:ext cx="102703" cy="101602"/>
            </a:xfrm>
            <a:prstGeom prst="ellipse">
              <a:avLst/>
            </a:prstGeom>
            <a:solidFill>
              <a:srgbClr val="00B050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30" name="TextBox 108">
              <a:extLst>
                <a:ext uri="{FF2B5EF4-FFF2-40B4-BE49-F238E27FC236}">
                  <a16:creationId xmlns:a16="http://schemas.microsoft.com/office/drawing/2014/main" id="{2CA56670-038B-8A9F-B95E-7D8C6CCB29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58308" y="3720106"/>
              <a:ext cx="389854" cy="2616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/>
                <a:t>DC</a:t>
              </a:r>
            </a:p>
          </p:txBody>
        </p:sp>
        <p:sp>
          <p:nvSpPr>
            <p:cNvPr id="31" name="TextBox 112">
              <a:extLst>
                <a:ext uri="{FF2B5EF4-FFF2-40B4-BE49-F238E27FC236}">
                  <a16:creationId xmlns:a16="http://schemas.microsoft.com/office/drawing/2014/main" id="{44AF8513-7CD7-6AF3-C457-8178A73299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22904" y="3434384"/>
              <a:ext cx="43473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4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sp>
          <p:nvSpPr>
            <p:cNvPr id="32" name="TextBox 125">
              <a:extLst>
                <a:ext uri="{FF2B5EF4-FFF2-40B4-BE49-F238E27FC236}">
                  <a16:creationId xmlns:a16="http://schemas.microsoft.com/office/drawing/2014/main" id="{EFC39A57-7DC2-F14B-B370-FDD0D089C7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124079">
              <a:off x="4021760" y="4188655"/>
              <a:ext cx="95250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10, </a:t>
              </a:r>
              <a:r>
                <a:rPr lang="en-US" altLang="en-US" sz="1100" b="1" dirty="0" err="1">
                  <a:solidFill>
                    <a:srgbClr val="003399"/>
                  </a:solidFill>
                </a:rPr>
                <a:t>TGF</a:t>
              </a:r>
              <a:r>
                <a:rPr lang="en-US" altLang="en-US" sz="1100" b="1" dirty="0" err="1">
                  <a:solidFill>
                    <a:srgbClr val="003399"/>
                  </a:solidFill>
                  <a:latin typeface="Symbol" panose="05050102010706020507" pitchFamily="18" charset="2"/>
                </a:rPr>
                <a:t>b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sp>
          <p:nvSpPr>
            <p:cNvPr id="33" name="Freeform 130">
              <a:extLst>
                <a:ext uri="{FF2B5EF4-FFF2-40B4-BE49-F238E27FC236}">
                  <a16:creationId xmlns:a16="http://schemas.microsoft.com/office/drawing/2014/main" id="{C7A8CE78-0018-1EFA-0D91-F0747539A74B}"/>
                </a:ext>
              </a:extLst>
            </p:cNvPr>
            <p:cNvSpPr>
              <a:spLocks/>
            </p:cNvSpPr>
            <p:nvPr/>
          </p:nvSpPr>
          <p:spPr bwMode="auto">
            <a:xfrm>
              <a:off x="7475793" y="2501039"/>
              <a:ext cx="1185035" cy="901378"/>
            </a:xfrm>
            <a:custGeom>
              <a:avLst/>
              <a:gdLst>
                <a:gd name="T0" fmla="*/ 46933 w 1185023"/>
                <a:gd name="T1" fmla="*/ 467390 h 901362"/>
                <a:gd name="T2" fmla="*/ 56461 w 1185023"/>
                <a:gd name="T3" fmla="*/ 353084 h 901362"/>
                <a:gd name="T4" fmla="*/ 113611 w 1185023"/>
                <a:gd name="T5" fmla="*/ 286406 h 901362"/>
                <a:gd name="T6" fmla="*/ 151714 w 1185023"/>
                <a:gd name="T7" fmla="*/ 124472 h 901362"/>
                <a:gd name="T8" fmla="*/ 294592 w 1185023"/>
                <a:gd name="T9" fmla="*/ 114947 h 901362"/>
                <a:gd name="T10" fmla="*/ 380320 w 1185023"/>
                <a:gd name="T11" fmla="*/ 641 h 901362"/>
                <a:gd name="T12" fmla="*/ 561301 w 1185023"/>
                <a:gd name="T13" fmla="*/ 67319 h 901362"/>
                <a:gd name="T14" fmla="*/ 799432 w 1185023"/>
                <a:gd name="T15" fmla="*/ 38744 h 901362"/>
                <a:gd name="T16" fmla="*/ 942313 w 1185023"/>
                <a:gd name="T17" fmla="*/ 181625 h 901362"/>
                <a:gd name="T18" fmla="*/ 1123291 w 1185023"/>
                <a:gd name="T19" fmla="*/ 276881 h 901362"/>
                <a:gd name="T20" fmla="*/ 1180444 w 1185023"/>
                <a:gd name="T21" fmla="*/ 534068 h 901362"/>
                <a:gd name="T22" fmla="*/ 1018513 w 1185023"/>
                <a:gd name="T23" fmla="*/ 772208 h 901362"/>
                <a:gd name="T24" fmla="*/ 866110 w 1185023"/>
                <a:gd name="T25" fmla="*/ 657902 h 901362"/>
                <a:gd name="T26" fmla="*/ 770857 w 1185023"/>
                <a:gd name="T27" fmla="*/ 886514 h 901362"/>
                <a:gd name="T28" fmla="*/ 475573 w 1185023"/>
                <a:gd name="T29" fmla="*/ 867461 h 901362"/>
                <a:gd name="T30" fmla="*/ 246967 w 1185023"/>
                <a:gd name="T31" fmla="*/ 772208 h 901362"/>
                <a:gd name="T32" fmla="*/ 323167 w 1185023"/>
                <a:gd name="T33" fmla="*/ 629324 h 901362"/>
                <a:gd name="T34" fmla="*/ 8833 w 1185023"/>
                <a:gd name="T35" fmla="*/ 638849 h 901362"/>
                <a:gd name="T36" fmla="*/ 85036 w 1185023"/>
                <a:gd name="T37" fmla="*/ 505493 h 901362"/>
                <a:gd name="T38" fmla="*/ 46933 w 1185023"/>
                <a:gd name="T39" fmla="*/ 467390 h 901362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</a:gdLst>
              <a:ahLst/>
              <a:cxnLst>
                <a:cxn ang="T40">
                  <a:pos x="T0" y="T1"/>
                </a:cxn>
                <a:cxn ang="T41">
                  <a:pos x="T2" y="T3"/>
                </a:cxn>
                <a:cxn ang="T42">
                  <a:pos x="T4" y="T5"/>
                </a:cxn>
                <a:cxn ang="T43">
                  <a:pos x="T6" y="T7"/>
                </a:cxn>
                <a:cxn ang="T44">
                  <a:pos x="T8" y="T9"/>
                </a:cxn>
                <a:cxn ang="T45">
                  <a:pos x="T10" y="T11"/>
                </a:cxn>
                <a:cxn ang="T46">
                  <a:pos x="T12" y="T13"/>
                </a:cxn>
                <a:cxn ang="T47">
                  <a:pos x="T14" y="T15"/>
                </a:cxn>
                <a:cxn ang="T48">
                  <a:pos x="T16" y="T17"/>
                </a:cxn>
                <a:cxn ang="T49">
                  <a:pos x="T18" y="T19"/>
                </a:cxn>
                <a:cxn ang="T50">
                  <a:pos x="T20" y="T21"/>
                </a:cxn>
                <a:cxn ang="T51">
                  <a:pos x="T22" y="T23"/>
                </a:cxn>
                <a:cxn ang="T52">
                  <a:pos x="T24" y="T25"/>
                </a:cxn>
                <a:cxn ang="T53">
                  <a:pos x="T26" y="T27"/>
                </a:cxn>
                <a:cxn ang="T54">
                  <a:pos x="T28" y="T29"/>
                </a:cxn>
                <a:cxn ang="T55">
                  <a:pos x="T30" y="T31"/>
                </a:cxn>
                <a:cxn ang="T56">
                  <a:pos x="T32" y="T33"/>
                </a:cxn>
                <a:cxn ang="T57">
                  <a:pos x="T34" y="T35"/>
                </a:cxn>
                <a:cxn ang="T58">
                  <a:pos x="T36" y="T37"/>
                </a:cxn>
                <a:cxn ang="T59">
                  <a:pos x="T38" y="T39"/>
                </a:cxn>
              </a:cxnLst>
              <a:rect l="0" t="0" r="r" b="b"/>
              <a:pathLst>
                <a:path w="1185023" h="901362">
                  <a:moveTo>
                    <a:pt x="46933" y="467366"/>
                  </a:moveTo>
                  <a:cubicBezTo>
                    <a:pt x="42171" y="441966"/>
                    <a:pt x="45346" y="383228"/>
                    <a:pt x="56458" y="353066"/>
                  </a:cubicBezTo>
                  <a:cubicBezTo>
                    <a:pt x="67570" y="322904"/>
                    <a:pt x="97733" y="324491"/>
                    <a:pt x="113608" y="286391"/>
                  </a:cubicBezTo>
                  <a:cubicBezTo>
                    <a:pt x="129483" y="248291"/>
                    <a:pt x="121546" y="153041"/>
                    <a:pt x="151708" y="124466"/>
                  </a:cubicBezTo>
                  <a:cubicBezTo>
                    <a:pt x="181870" y="95891"/>
                    <a:pt x="256483" y="135578"/>
                    <a:pt x="294583" y="114941"/>
                  </a:cubicBezTo>
                  <a:cubicBezTo>
                    <a:pt x="332683" y="94304"/>
                    <a:pt x="335858" y="8578"/>
                    <a:pt x="380308" y="641"/>
                  </a:cubicBezTo>
                  <a:cubicBezTo>
                    <a:pt x="424758" y="-7296"/>
                    <a:pt x="491433" y="60966"/>
                    <a:pt x="561283" y="67316"/>
                  </a:cubicBezTo>
                  <a:cubicBezTo>
                    <a:pt x="631133" y="73666"/>
                    <a:pt x="735908" y="19691"/>
                    <a:pt x="799408" y="38741"/>
                  </a:cubicBezTo>
                  <a:cubicBezTo>
                    <a:pt x="862908" y="57791"/>
                    <a:pt x="888308" y="141928"/>
                    <a:pt x="942283" y="181616"/>
                  </a:cubicBezTo>
                  <a:cubicBezTo>
                    <a:pt x="996258" y="221303"/>
                    <a:pt x="1083571" y="218129"/>
                    <a:pt x="1123258" y="276866"/>
                  </a:cubicBezTo>
                  <a:cubicBezTo>
                    <a:pt x="1162945" y="335603"/>
                    <a:pt x="1197870" y="451491"/>
                    <a:pt x="1180408" y="534041"/>
                  </a:cubicBezTo>
                  <a:cubicBezTo>
                    <a:pt x="1162946" y="616591"/>
                    <a:pt x="1070871" y="751529"/>
                    <a:pt x="1018483" y="772166"/>
                  </a:cubicBezTo>
                  <a:cubicBezTo>
                    <a:pt x="966096" y="792804"/>
                    <a:pt x="907358" y="638816"/>
                    <a:pt x="866083" y="657866"/>
                  </a:cubicBezTo>
                  <a:cubicBezTo>
                    <a:pt x="824808" y="676916"/>
                    <a:pt x="835921" y="851541"/>
                    <a:pt x="770833" y="886466"/>
                  </a:cubicBezTo>
                  <a:cubicBezTo>
                    <a:pt x="705745" y="921391"/>
                    <a:pt x="562870" y="886466"/>
                    <a:pt x="475558" y="867416"/>
                  </a:cubicBezTo>
                  <a:cubicBezTo>
                    <a:pt x="388246" y="848366"/>
                    <a:pt x="272358" y="811854"/>
                    <a:pt x="246958" y="772166"/>
                  </a:cubicBezTo>
                  <a:cubicBezTo>
                    <a:pt x="221558" y="732479"/>
                    <a:pt x="362845" y="651516"/>
                    <a:pt x="323158" y="629291"/>
                  </a:cubicBezTo>
                  <a:cubicBezTo>
                    <a:pt x="283471" y="607066"/>
                    <a:pt x="48521" y="659454"/>
                    <a:pt x="8833" y="638816"/>
                  </a:cubicBezTo>
                  <a:cubicBezTo>
                    <a:pt x="-30855" y="618179"/>
                    <a:pt x="75508" y="540391"/>
                    <a:pt x="85033" y="505466"/>
                  </a:cubicBezTo>
                  <a:cubicBezTo>
                    <a:pt x="94558" y="470541"/>
                    <a:pt x="51695" y="492766"/>
                    <a:pt x="46933" y="467366"/>
                  </a:cubicBezTo>
                  <a:close/>
                </a:path>
              </a:pathLst>
            </a:custGeom>
            <a:solidFill>
              <a:srgbClr val="CC00FF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wrap="none">
              <a:spAutoFit/>
            </a:bodyPr>
            <a:lstStyle/>
            <a:p>
              <a:endParaRPr lang="en-US"/>
            </a:p>
          </p:txBody>
        </p:sp>
        <p:sp>
          <p:nvSpPr>
            <p:cNvPr id="34" name="Oval 9">
              <a:extLst>
                <a:ext uri="{FF2B5EF4-FFF2-40B4-BE49-F238E27FC236}">
                  <a16:creationId xmlns:a16="http://schemas.microsoft.com/office/drawing/2014/main" id="{62D1A936-2F76-FB0E-8A34-BB4322657A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62867" y="2806092"/>
              <a:ext cx="610886" cy="274325"/>
            </a:xfrm>
            <a:prstGeom prst="ellipse">
              <a:avLst/>
            </a:prstGeom>
            <a:solidFill>
              <a:srgbClr val="FFFF00"/>
            </a:solidFill>
            <a:ln w="12700" algn="ctr">
              <a:solidFill>
                <a:srgbClr val="FF9933"/>
              </a:solidFill>
              <a:round/>
              <a:headEnd/>
              <a:tailEnd/>
            </a:ln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35" name="TextBox 134">
              <a:extLst>
                <a:ext uri="{FF2B5EF4-FFF2-40B4-BE49-F238E27FC236}">
                  <a16:creationId xmlns:a16="http://schemas.microsoft.com/office/drawing/2014/main" id="{E26003CC-AB12-872F-9606-FF3BBE6DCC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0191345">
              <a:off x="6567714" y="3393950"/>
              <a:ext cx="76174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4, IL-5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sp>
          <p:nvSpPr>
            <p:cNvPr id="36" name="TextBox 146">
              <a:extLst>
                <a:ext uri="{FF2B5EF4-FFF2-40B4-BE49-F238E27FC236}">
                  <a16:creationId xmlns:a16="http://schemas.microsoft.com/office/drawing/2014/main" id="{4E5C9E91-2651-2C37-0EE2-EAD2EBF0F9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98012" y="5094208"/>
              <a:ext cx="54373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10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 err="1">
                  <a:solidFill>
                    <a:srgbClr val="003399"/>
                  </a:solidFill>
                </a:rPr>
                <a:t>TGF</a:t>
              </a:r>
              <a:r>
                <a:rPr lang="en-US" altLang="en-US" sz="1100" b="1" dirty="0" err="1">
                  <a:solidFill>
                    <a:srgbClr val="003399"/>
                  </a:solidFill>
                  <a:latin typeface="Symbol" panose="05050102010706020507" pitchFamily="18" charset="2"/>
                </a:rPr>
                <a:t>b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sp>
          <p:nvSpPr>
            <p:cNvPr id="37" name="TextBox 147">
              <a:extLst>
                <a:ext uri="{FF2B5EF4-FFF2-40B4-BE49-F238E27FC236}">
                  <a16:creationId xmlns:a16="http://schemas.microsoft.com/office/drawing/2014/main" id="{6B79406C-5E35-F327-96C2-3C33B05A46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92928" y="2801521"/>
              <a:ext cx="783355" cy="7694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/>
                <a:t>Mast cell</a:t>
              </a:r>
            </a:p>
            <a:p>
              <a:pPr>
                <a:spcBef>
                  <a:spcPct val="0"/>
                </a:spcBef>
                <a:buFontTx/>
                <a:buNone/>
              </a:pPr>
              <a:endParaRPr lang="en-US" altLang="en-US" sz="1100" b="1" dirty="0">
                <a:latin typeface="Symbol" panose="05050102010706020507" pitchFamily="18" charset="2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endParaRPr lang="en-US" altLang="en-US" sz="1100" b="1" dirty="0">
                <a:latin typeface="Symbol" panose="05050102010706020507" pitchFamily="18" charset="2"/>
              </a:endParaRPr>
            </a:p>
            <a:p>
              <a:pPr>
                <a:spcBef>
                  <a:spcPct val="0"/>
                </a:spcBef>
                <a:buFontTx/>
                <a:buNone/>
              </a:pPr>
              <a:endParaRPr lang="en-US" altLang="en-US" sz="1100" b="1" dirty="0">
                <a:latin typeface="Symbol" panose="05050102010706020507" pitchFamily="18" charset="2"/>
              </a:endParaRPr>
            </a:p>
          </p:txBody>
        </p:sp>
        <p:sp>
          <p:nvSpPr>
            <p:cNvPr id="38" name="Freeform 151">
              <a:extLst>
                <a:ext uri="{FF2B5EF4-FFF2-40B4-BE49-F238E27FC236}">
                  <a16:creationId xmlns:a16="http://schemas.microsoft.com/office/drawing/2014/main" id="{72224FB9-A166-AA9F-D02E-EA769D9C1DBB}"/>
                </a:ext>
              </a:extLst>
            </p:cNvPr>
            <p:cNvSpPr>
              <a:spLocks/>
            </p:cNvSpPr>
            <p:nvPr/>
          </p:nvSpPr>
          <p:spPr bwMode="auto">
            <a:xfrm>
              <a:off x="7644534" y="3609952"/>
              <a:ext cx="889010" cy="793977"/>
            </a:xfrm>
            <a:custGeom>
              <a:avLst/>
              <a:gdLst>
                <a:gd name="T0" fmla="*/ 247997 w 889001"/>
                <a:gd name="T1" fmla="*/ 10936 h 793963"/>
                <a:gd name="T2" fmla="*/ 571856 w 889001"/>
                <a:gd name="T3" fmla="*/ 20461 h 793963"/>
                <a:gd name="T4" fmla="*/ 714734 w 889001"/>
                <a:gd name="T5" fmla="*/ 87142 h 793963"/>
                <a:gd name="T6" fmla="*/ 829037 w 889001"/>
                <a:gd name="T7" fmla="*/ 277651 h 793963"/>
                <a:gd name="T8" fmla="*/ 886190 w 889001"/>
                <a:gd name="T9" fmla="*/ 506263 h 793963"/>
                <a:gd name="T10" fmla="*/ 743312 w 889001"/>
                <a:gd name="T11" fmla="*/ 706297 h 793963"/>
                <a:gd name="T12" fmla="*/ 381350 w 889001"/>
                <a:gd name="T13" fmla="*/ 792028 h 793963"/>
                <a:gd name="T14" fmla="*/ 105116 w 889001"/>
                <a:gd name="T15" fmla="*/ 630094 h 793963"/>
                <a:gd name="T16" fmla="*/ 338 w 889001"/>
                <a:gd name="T17" fmla="*/ 334804 h 793963"/>
                <a:gd name="T18" fmla="*/ 133691 w 889001"/>
                <a:gd name="T19" fmla="*/ 163345 h 793963"/>
                <a:gd name="T20" fmla="*/ 247997 w 889001"/>
                <a:gd name="T21" fmla="*/ 10936 h 793963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</a:gdLst>
              <a:ahLst/>
              <a:cxnLst>
                <a:cxn ang="T22">
                  <a:pos x="T0" y="T1"/>
                </a:cxn>
                <a:cxn ang="T23">
                  <a:pos x="T2" y="T3"/>
                </a:cxn>
                <a:cxn ang="T24">
                  <a:pos x="T4" y="T5"/>
                </a:cxn>
                <a:cxn ang="T25">
                  <a:pos x="T6" y="T7"/>
                </a:cxn>
                <a:cxn ang="T26">
                  <a:pos x="T8" y="T9"/>
                </a:cxn>
                <a:cxn ang="T27">
                  <a:pos x="T10" y="T11"/>
                </a:cxn>
                <a:cxn ang="T28">
                  <a:pos x="T12" y="T13"/>
                </a:cxn>
                <a:cxn ang="T29">
                  <a:pos x="T14" y="T15"/>
                </a:cxn>
                <a:cxn ang="T30">
                  <a:pos x="T16" y="T17"/>
                </a:cxn>
                <a:cxn ang="T31">
                  <a:pos x="T18" y="T19"/>
                </a:cxn>
                <a:cxn ang="T32">
                  <a:pos x="T20" y="T21"/>
                </a:cxn>
              </a:cxnLst>
              <a:rect l="0" t="0" r="r" b="b"/>
              <a:pathLst>
                <a:path w="889001" h="793963">
                  <a:moveTo>
                    <a:pt x="247988" y="10936"/>
                  </a:moveTo>
                  <a:cubicBezTo>
                    <a:pt x="321013" y="-12877"/>
                    <a:pt x="494051" y="7761"/>
                    <a:pt x="571838" y="20461"/>
                  </a:cubicBezTo>
                  <a:cubicBezTo>
                    <a:pt x="649626" y="33161"/>
                    <a:pt x="671851" y="44274"/>
                    <a:pt x="714713" y="87136"/>
                  </a:cubicBezTo>
                  <a:cubicBezTo>
                    <a:pt x="757575" y="129998"/>
                    <a:pt x="800438" y="207786"/>
                    <a:pt x="829013" y="277636"/>
                  </a:cubicBezTo>
                  <a:cubicBezTo>
                    <a:pt x="857588" y="347486"/>
                    <a:pt x="900451" y="434799"/>
                    <a:pt x="886163" y="506236"/>
                  </a:cubicBezTo>
                  <a:cubicBezTo>
                    <a:pt x="871876" y="577674"/>
                    <a:pt x="827426" y="658636"/>
                    <a:pt x="743288" y="706261"/>
                  </a:cubicBezTo>
                  <a:cubicBezTo>
                    <a:pt x="659150" y="753886"/>
                    <a:pt x="487700" y="804686"/>
                    <a:pt x="381338" y="791986"/>
                  </a:cubicBezTo>
                  <a:cubicBezTo>
                    <a:pt x="274976" y="779286"/>
                    <a:pt x="168613" y="706261"/>
                    <a:pt x="105113" y="630061"/>
                  </a:cubicBezTo>
                  <a:cubicBezTo>
                    <a:pt x="41613" y="553861"/>
                    <a:pt x="-4424" y="412573"/>
                    <a:pt x="338" y="334786"/>
                  </a:cubicBezTo>
                  <a:cubicBezTo>
                    <a:pt x="5100" y="256999"/>
                    <a:pt x="95588" y="215723"/>
                    <a:pt x="133688" y="163336"/>
                  </a:cubicBezTo>
                  <a:cubicBezTo>
                    <a:pt x="171788" y="110949"/>
                    <a:pt x="174963" y="34749"/>
                    <a:pt x="247988" y="10936"/>
                  </a:cubicBezTo>
                  <a:close/>
                </a:path>
              </a:pathLst>
            </a:custGeom>
            <a:solidFill>
              <a:srgbClr val="FFCCFF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wrap="none">
              <a:spAutoFit/>
            </a:bodyPr>
            <a:lstStyle/>
            <a:p>
              <a:endParaRPr lang="en-US"/>
            </a:p>
          </p:txBody>
        </p:sp>
        <p:sp>
          <p:nvSpPr>
            <p:cNvPr id="39" name="Freeform 152">
              <a:extLst>
                <a:ext uri="{FF2B5EF4-FFF2-40B4-BE49-F238E27FC236}">
                  <a16:creationId xmlns:a16="http://schemas.microsoft.com/office/drawing/2014/main" id="{CA6EC266-AE02-052E-D5A8-F5A63F14E7AE}"/>
                </a:ext>
              </a:extLst>
            </p:cNvPr>
            <p:cNvSpPr>
              <a:spLocks/>
            </p:cNvSpPr>
            <p:nvPr/>
          </p:nvSpPr>
          <p:spPr bwMode="auto">
            <a:xfrm>
              <a:off x="7794219" y="3811163"/>
              <a:ext cx="545986" cy="467707"/>
            </a:xfrm>
            <a:custGeom>
              <a:avLst/>
              <a:gdLst>
                <a:gd name="T0" fmla="*/ 279289 w 545980"/>
                <a:gd name="T1" fmla="*/ 466978 h 467699"/>
                <a:gd name="T2" fmla="*/ 403117 w 545980"/>
                <a:gd name="T3" fmla="*/ 409825 h 467699"/>
                <a:gd name="T4" fmla="*/ 336442 w 545980"/>
                <a:gd name="T5" fmla="*/ 343147 h 467699"/>
                <a:gd name="T6" fmla="*/ 231664 w 545980"/>
                <a:gd name="T7" fmla="*/ 343147 h 467699"/>
                <a:gd name="T8" fmla="*/ 136408 w 545980"/>
                <a:gd name="T9" fmla="*/ 295519 h 467699"/>
                <a:gd name="T10" fmla="*/ 117358 w 545980"/>
                <a:gd name="T11" fmla="*/ 181213 h 467699"/>
                <a:gd name="T12" fmla="*/ 136408 w 545980"/>
                <a:gd name="T13" fmla="*/ 114535 h 467699"/>
                <a:gd name="T14" fmla="*/ 193561 w 545980"/>
                <a:gd name="T15" fmla="*/ 66907 h 467699"/>
                <a:gd name="T16" fmla="*/ 307864 w 545980"/>
                <a:gd name="T17" fmla="*/ 95485 h 467699"/>
                <a:gd name="T18" fmla="*/ 393592 w 545980"/>
                <a:gd name="T19" fmla="*/ 143110 h 467699"/>
                <a:gd name="T20" fmla="*/ 450745 w 545980"/>
                <a:gd name="T21" fmla="*/ 228841 h 467699"/>
                <a:gd name="T22" fmla="*/ 507898 w 545980"/>
                <a:gd name="T23" fmla="*/ 295519 h 467699"/>
                <a:gd name="T24" fmla="*/ 545998 w 545980"/>
                <a:gd name="T25" fmla="*/ 228841 h 467699"/>
                <a:gd name="T26" fmla="*/ 507898 w 545980"/>
                <a:gd name="T27" fmla="*/ 95485 h 467699"/>
                <a:gd name="T28" fmla="*/ 384067 w 545980"/>
                <a:gd name="T29" fmla="*/ 38332 h 467699"/>
                <a:gd name="T30" fmla="*/ 222136 w 545980"/>
                <a:gd name="T31" fmla="*/ 229 h 467699"/>
                <a:gd name="T32" fmla="*/ 69733 w 545980"/>
                <a:gd name="T33" fmla="*/ 28804 h 467699"/>
                <a:gd name="T34" fmla="*/ 3055 w 545980"/>
                <a:gd name="T35" fmla="*/ 143110 h 467699"/>
                <a:gd name="T36" fmla="*/ 22105 w 545980"/>
                <a:gd name="T37" fmla="*/ 285994 h 467699"/>
                <a:gd name="T38" fmla="*/ 117358 w 545980"/>
                <a:gd name="T39" fmla="*/ 381250 h 467699"/>
                <a:gd name="T40" fmla="*/ 231664 w 545980"/>
                <a:gd name="T41" fmla="*/ 438400 h 467699"/>
                <a:gd name="T42" fmla="*/ 279289 w 545980"/>
                <a:gd name="T43" fmla="*/ 466978 h 467699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</a:gdLst>
              <a:ahLst/>
              <a:cxnLst>
                <a:cxn ang="T44">
                  <a:pos x="T0" y="T1"/>
                </a:cxn>
                <a:cxn ang="T45">
                  <a:pos x="T2" y="T3"/>
                </a:cxn>
                <a:cxn ang="T46">
                  <a:pos x="T4" y="T5"/>
                </a:cxn>
                <a:cxn ang="T47">
                  <a:pos x="T6" y="T7"/>
                </a:cxn>
                <a:cxn ang="T48">
                  <a:pos x="T8" y="T9"/>
                </a:cxn>
                <a:cxn ang="T49">
                  <a:pos x="T10" y="T11"/>
                </a:cxn>
                <a:cxn ang="T50">
                  <a:pos x="T12" y="T13"/>
                </a:cxn>
                <a:cxn ang="T51">
                  <a:pos x="T14" y="T15"/>
                </a:cxn>
                <a:cxn ang="T52">
                  <a:pos x="T16" y="T17"/>
                </a:cxn>
                <a:cxn ang="T53">
                  <a:pos x="T18" y="T19"/>
                </a:cxn>
                <a:cxn ang="T54">
                  <a:pos x="T20" y="T21"/>
                </a:cxn>
                <a:cxn ang="T55">
                  <a:pos x="T22" y="T23"/>
                </a:cxn>
                <a:cxn ang="T56">
                  <a:pos x="T24" y="T25"/>
                </a:cxn>
                <a:cxn ang="T57">
                  <a:pos x="T26" y="T27"/>
                </a:cxn>
                <a:cxn ang="T58">
                  <a:pos x="T28" y="T29"/>
                </a:cxn>
                <a:cxn ang="T59">
                  <a:pos x="T30" y="T31"/>
                </a:cxn>
                <a:cxn ang="T60">
                  <a:pos x="T32" y="T33"/>
                </a:cxn>
                <a:cxn ang="T61">
                  <a:pos x="T34" y="T35"/>
                </a:cxn>
                <a:cxn ang="T62">
                  <a:pos x="T36" y="T37"/>
                </a:cxn>
                <a:cxn ang="T63">
                  <a:pos x="T38" y="T39"/>
                </a:cxn>
                <a:cxn ang="T64">
                  <a:pos x="T40" y="T41"/>
                </a:cxn>
                <a:cxn ang="T65">
                  <a:pos x="T42" y="T43"/>
                </a:cxn>
              </a:cxnLst>
              <a:rect l="0" t="0" r="r" b="b"/>
              <a:pathLst>
                <a:path w="545980" h="467699">
                  <a:moveTo>
                    <a:pt x="279280" y="466954"/>
                  </a:moveTo>
                  <a:cubicBezTo>
                    <a:pt x="307855" y="462192"/>
                    <a:pt x="393580" y="430441"/>
                    <a:pt x="403105" y="409804"/>
                  </a:cubicBezTo>
                  <a:cubicBezTo>
                    <a:pt x="412630" y="389167"/>
                    <a:pt x="365005" y="354241"/>
                    <a:pt x="336430" y="343129"/>
                  </a:cubicBezTo>
                  <a:cubicBezTo>
                    <a:pt x="307855" y="332017"/>
                    <a:pt x="264992" y="351066"/>
                    <a:pt x="231655" y="343129"/>
                  </a:cubicBezTo>
                  <a:cubicBezTo>
                    <a:pt x="198318" y="335192"/>
                    <a:pt x="155455" y="322491"/>
                    <a:pt x="136405" y="295504"/>
                  </a:cubicBezTo>
                  <a:cubicBezTo>
                    <a:pt x="117355" y="268517"/>
                    <a:pt x="117355" y="211366"/>
                    <a:pt x="117355" y="181204"/>
                  </a:cubicBezTo>
                  <a:cubicBezTo>
                    <a:pt x="117355" y="151042"/>
                    <a:pt x="123705" y="133579"/>
                    <a:pt x="136405" y="114529"/>
                  </a:cubicBezTo>
                  <a:cubicBezTo>
                    <a:pt x="149105" y="95479"/>
                    <a:pt x="164980" y="70079"/>
                    <a:pt x="193555" y="66904"/>
                  </a:cubicBezTo>
                  <a:cubicBezTo>
                    <a:pt x="222130" y="63729"/>
                    <a:pt x="274517" y="82779"/>
                    <a:pt x="307855" y="95479"/>
                  </a:cubicBezTo>
                  <a:cubicBezTo>
                    <a:pt x="341193" y="108179"/>
                    <a:pt x="369768" y="120879"/>
                    <a:pt x="393580" y="143104"/>
                  </a:cubicBezTo>
                  <a:cubicBezTo>
                    <a:pt x="417392" y="165329"/>
                    <a:pt x="431680" y="203429"/>
                    <a:pt x="450730" y="228829"/>
                  </a:cubicBezTo>
                  <a:cubicBezTo>
                    <a:pt x="469780" y="254229"/>
                    <a:pt x="492005" y="295504"/>
                    <a:pt x="507880" y="295504"/>
                  </a:cubicBezTo>
                  <a:cubicBezTo>
                    <a:pt x="523755" y="295504"/>
                    <a:pt x="545980" y="262166"/>
                    <a:pt x="545980" y="228829"/>
                  </a:cubicBezTo>
                  <a:cubicBezTo>
                    <a:pt x="545980" y="195492"/>
                    <a:pt x="534867" y="127229"/>
                    <a:pt x="507880" y="95479"/>
                  </a:cubicBezTo>
                  <a:cubicBezTo>
                    <a:pt x="480893" y="63729"/>
                    <a:pt x="431680" y="54204"/>
                    <a:pt x="384055" y="38329"/>
                  </a:cubicBezTo>
                  <a:cubicBezTo>
                    <a:pt x="336430" y="22454"/>
                    <a:pt x="274517" y="1816"/>
                    <a:pt x="222130" y="229"/>
                  </a:cubicBezTo>
                  <a:cubicBezTo>
                    <a:pt x="169743" y="-1358"/>
                    <a:pt x="106242" y="4992"/>
                    <a:pt x="69730" y="28804"/>
                  </a:cubicBezTo>
                  <a:cubicBezTo>
                    <a:pt x="33218" y="52616"/>
                    <a:pt x="10992" y="100242"/>
                    <a:pt x="3055" y="143104"/>
                  </a:cubicBezTo>
                  <a:cubicBezTo>
                    <a:pt x="-4882" y="185966"/>
                    <a:pt x="3055" y="246291"/>
                    <a:pt x="22105" y="285979"/>
                  </a:cubicBezTo>
                  <a:cubicBezTo>
                    <a:pt x="41155" y="325667"/>
                    <a:pt x="82430" y="355829"/>
                    <a:pt x="117355" y="381229"/>
                  </a:cubicBezTo>
                  <a:cubicBezTo>
                    <a:pt x="152280" y="406629"/>
                    <a:pt x="201493" y="424092"/>
                    <a:pt x="231655" y="438379"/>
                  </a:cubicBezTo>
                  <a:cubicBezTo>
                    <a:pt x="261817" y="452666"/>
                    <a:pt x="250705" y="471716"/>
                    <a:pt x="279280" y="466954"/>
                  </a:cubicBezTo>
                  <a:close/>
                </a:path>
              </a:pathLst>
            </a:cu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wrap="none">
              <a:spAutoFit/>
            </a:bodyPr>
            <a:lstStyle/>
            <a:p>
              <a:endParaRPr lang="en-US"/>
            </a:p>
          </p:txBody>
        </p:sp>
        <p:sp>
          <p:nvSpPr>
            <p:cNvPr id="40" name="Oval 153">
              <a:extLst>
                <a:ext uri="{FF2B5EF4-FFF2-40B4-BE49-F238E27FC236}">
                  <a16:creationId xmlns:a16="http://schemas.microsoft.com/office/drawing/2014/main" id="{64907C8C-9130-0EFD-F865-564F33E5AF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04730" y="3681212"/>
              <a:ext cx="73599" cy="61915"/>
            </a:xfrm>
            <a:prstGeom prst="ellipse">
              <a:avLst/>
            </a:prstGeom>
            <a:solidFill>
              <a:srgbClr val="CC00FF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41" name="Oval 154">
              <a:extLst>
                <a:ext uri="{FF2B5EF4-FFF2-40B4-BE49-F238E27FC236}">
                  <a16:creationId xmlns:a16="http://schemas.microsoft.com/office/drawing/2014/main" id="{7B5F16EE-5647-31D0-DDF3-70A609157C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90971" y="3777255"/>
              <a:ext cx="73599" cy="61915"/>
            </a:xfrm>
            <a:prstGeom prst="ellipse">
              <a:avLst/>
            </a:prstGeom>
            <a:solidFill>
              <a:srgbClr val="CC00FF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42" name="Oval 156">
              <a:extLst>
                <a:ext uri="{FF2B5EF4-FFF2-40B4-BE49-F238E27FC236}">
                  <a16:creationId xmlns:a16="http://schemas.microsoft.com/office/drawing/2014/main" id="{908BE5C1-E0B5-050C-3AE4-0AE0EF0951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2239" y="4006940"/>
              <a:ext cx="73599" cy="61915"/>
            </a:xfrm>
            <a:prstGeom prst="ellipse">
              <a:avLst/>
            </a:prstGeom>
            <a:solidFill>
              <a:srgbClr val="CC00FF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43" name="Oval 157">
              <a:extLst>
                <a:ext uri="{FF2B5EF4-FFF2-40B4-BE49-F238E27FC236}">
                  <a16:creationId xmlns:a16="http://schemas.microsoft.com/office/drawing/2014/main" id="{4879C8D6-28A6-E52E-E3C7-B7CB9DC41D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66606" y="4207367"/>
              <a:ext cx="73599" cy="61915"/>
            </a:xfrm>
            <a:prstGeom prst="ellipse">
              <a:avLst/>
            </a:prstGeom>
            <a:solidFill>
              <a:srgbClr val="CC00FF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44" name="Oval 158">
              <a:extLst>
                <a:ext uri="{FF2B5EF4-FFF2-40B4-BE49-F238E27FC236}">
                  <a16:creationId xmlns:a16="http://schemas.microsoft.com/office/drawing/2014/main" id="{36903221-3A5D-8CBC-698B-C33769BCEE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92549" y="4053837"/>
              <a:ext cx="73599" cy="61915"/>
            </a:xfrm>
            <a:prstGeom prst="ellipse">
              <a:avLst/>
            </a:prstGeom>
            <a:solidFill>
              <a:srgbClr val="CC00FF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45" name="TextBox 159">
              <a:extLst>
                <a:ext uri="{FF2B5EF4-FFF2-40B4-BE49-F238E27FC236}">
                  <a16:creationId xmlns:a16="http://schemas.microsoft.com/office/drawing/2014/main" id="{974B9DAE-ED3C-2D79-2384-34D3EE4117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708644" y="4344619"/>
              <a:ext cx="90601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/>
                <a:t>Eosinophil</a:t>
              </a:r>
            </a:p>
          </p:txBody>
        </p:sp>
        <p:sp>
          <p:nvSpPr>
            <p:cNvPr id="46" name="TextBox 164">
              <a:extLst>
                <a:ext uri="{FF2B5EF4-FFF2-40B4-BE49-F238E27FC236}">
                  <a16:creationId xmlns:a16="http://schemas.microsoft.com/office/drawing/2014/main" id="{1BDE3376-73F8-CB10-009F-7D34F16852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85662" y="4351884"/>
              <a:ext cx="43473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4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cxnSp>
          <p:nvCxnSpPr>
            <p:cNvPr id="47" name="Straight Connector 68">
              <a:extLst>
                <a:ext uri="{FF2B5EF4-FFF2-40B4-BE49-F238E27FC236}">
                  <a16:creationId xmlns:a16="http://schemas.microsoft.com/office/drawing/2014/main" id="{92F62D0D-5826-FC7C-5E2A-8B34CB9BC78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5094508" y="5125118"/>
              <a:ext cx="10095" cy="329986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8" name="TextBox 125">
              <a:extLst>
                <a:ext uri="{FF2B5EF4-FFF2-40B4-BE49-F238E27FC236}">
                  <a16:creationId xmlns:a16="http://schemas.microsoft.com/office/drawing/2014/main" id="{00F9EC38-CD94-3C98-4192-C3316A6891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614831">
              <a:off x="9107425" y="2789998"/>
              <a:ext cx="542925" cy="431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10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 err="1">
                  <a:solidFill>
                    <a:srgbClr val="003399"/>
                  </a:solidFill>
                </a:rPr>
                <a:t>TGF</a:t>
              </a:r>
              <a:r>
                <a:rPr lang="en-US" altLang="en-US" sz="1100" b="1" dirty="0" err="1">
                  <a:solidFill>
                    <a:srgbClr val="003399"/>
                  </a:solidFill>
                  <a:latin typeface="Symbol" panose="05050102010706020507" pitchFamily="18" charset="2"/>
                </a:rPr>
                <a:t>b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grpSp>
          <p:nvGrpSpPr>
            <p:cNvPr id="49" name="Group 29">
              <a:extLst>
                <a:ext uri="{FF2B5EF4-FFF2-40B4-BE49-F238E27FC236}">
                  <a16:creationId xmlns:a16="http://schemas.microsoft.com/office/drawing/2014/main" id="{24568D74-80D1-6B9D-2DDD-B1BE12ED5F39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9886362" y="2639750"/>
              <a:ext cx="959964" cy="914416"/>
              <a:chOff x="1333723" y="1766067"/>
              <a:chExt cx="1371600" cy="1306514"/>
            </a:xfrm>
          </p:grpSpPr>
          <p:sp>
            <p:nvSpPr>
              <p:cNvPr id="107" name="Oval 8">
                <a:extLst>
                  <a:ext uri="{FF2B5EF4-FFF2-40B4-BE49-F238E27FC236}">
                    <a16:creationId xmlns:a16="http://schemas.microsoft.com/office/drawing/2014/main" id="{62FE8B10-1323-905D-7681-33CB1A253B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3723" y="1766067"/>
                <a:ext cx="1371600" cy="1306514"/>
              </a:xfrm>
              <a:prstGeom prst="ellipse">
                <a:avLst/>
              </a:prstGeom>
              <a:solidFill>
                <a:srgbClr val="66FF33"/>
              </a:solidFill>
              <a:ln w="12700" algn="ctr">
                <a:solidFill>
                  <a:srgbClr val="FF9933"/>
                </a:solidFill>
                <a:round/>
                <a:headEnd/>
                <a:tailEnd/>
              </a:ln>
            </p:spPr>
            <p:txBody>
              <a:bodyPr anchor="ctr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2400"/>
              </a:p>
            </p:txBody>
          </p:sp>
          <p:sp>
            <p:nvSpPr>
              <p:cNvPr id="108" name="Oval 9">
                <a:extLst>
                  <a:ext uri="{FF2B5EF4-FFF2-40B4-BE49-F238E27FC236}">
                    <a16:creationId xmlns:a16="http://schemas.microsoft.com/office/drawing/2014/main" id="{8CA881F9-352E-9483-C0E0-C555879E52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6123" y="1983555"/>
                <a:ext cx="872836" cy="783335"/>
              </a:xfrm>
              <a:prstGeom prst="ellipse">
                <a:avLst/>
              </a:prstGeom>
              <a:solidFill>
                <a:srgbClr val="FFFF00"/>
              </a:solidFill>
              <a:ln w="12700" algn="ctr">
                <a:solidFill>
                  <a:srgbClr val="FF9933"/>
                </a:solidFill>
                <a:round/>
                <a:headEnd/>
                <a:tailEnd/>
              </a:ln>
            </p:spPr>
            <p:txBody>
              <a:bodyPr anchor="ctr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en-US" sz="2400"/>
              </a:p>
            </p:txBody>
          </p:sp>
        </p:grpSp>
        <p:sp>
          <p:nvSpPr>
            <p:cNvPr id="50" name="TextBox 90">
              <a:extLst>
                <a:ext uri="{FF2B5EF4-FFF2-40B4-BE49-F238E27FC236}">
                  <a16:creationId xmlns:a16="http://schemas.microsoft.com/office/drawing/2014/main" id="{D56A2B85-17B4-A2EB-A184-986A1EB542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061061" y="2935285"/>
              <a:ext cx="49084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/>
                <a:t>Treg</a:t>
              </a:r>
            </a:p>
          </p:txBody>
        </p: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D8C85B4E-D30C-E17B-BB13-B2C57936B2D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85561" y="4188762"/>
              <a:ext cx="11605" cy="599201"/>
            </a:xfrm>
            <a:prstGeom prst="straightConnector1">
              <a:avLst/>
            </a:prstGeom>
            <a:ln w="12700"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E33BA734-8DD1-662B-7F0C-43D302FDE0DF}"/>
                </a:ext>
              </a:extLst>
            </p:cNvPr>
            <p:cNvCxnSpPr>
              <a:cxnSpLocks/>
            </p:cNvCxnSpPr>
            <p:nvPr/>
          </p:nvCxnSpPr>
          <p:spPr>
            <a:xfrm>
              <a:off x="4414271" y="3675006"/>
              <a:ext cx="603079" cy="0"/>
            </a:xfrm>
            <a:prstGeom prst="straightConnector1">
              <a:avLst/>
            </a:prstGeom>
            <a:ln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6875F7C7-681E-DB12-4E3E-FC34A8EA79CC}"/>
                </a:ext>
              </a:extLst>
            </p:cNvPr>
            <p:cNvCxnSpPr>
              <a:cxnSpLocks/>
            </p:cNvCxnSpPr>
            <p:nvPr/>
          </p:nvCxnSpPr>
          <p:spPr>
            <a:xfrm>
              <a:off x="6225721" y="3880304"/>
              <a:ext cx="1229391" cy="24586"/>
            </a:xfrm>
            <a:prstGeom prst="straightConnector1">
              <a:avLst/>
            </a:prstGeom>
            <a:ln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BF7D6281-A8B4-04F3-C132-1813216377D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75510" y="2919171"/>
              <a:ext cx="1228339" cy="564195"/>
            </a:xfrm>
            <a:prstGeom prst="straightConnector1">
              <a:avLst/>
            </a:prstGeom>
            <a:ln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112">
              <a:extLst>
                <a:ext uri="{FF2B5EF4-FFF2-40B4-BE49-F238E27FC236}">
                  <a16:creationId xmlns:a16="http://schemas.microsoft.com/office/drawing/2014/main" id="{42AD6609-AB25-AFB6-2A96-AC52946FE2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0006993">
              <a:off x="6518678" y="2972810"/>
              <a:ext cx="43473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4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CA4A4F64-7014-26E1-4664-5C7F20D2C0B3}"/>
                </a:ext>
              </a:extLst>
            </p:cNvPr>
            <p:cNvCxnSpPr>
              <a:cxnSpLocks/>
            </p:cNvCxnSpPr>
            <p:nvPr/>
          </p:nvCxnSpPr>
          <p:spPr>
            <a:xfrm>
              <a:off x="6122133" y="4184884"/>
              <a:ext cx="1376901" cy="805947"/>
            </a:xfrm>
            <a:prstGeom prst="straightConnector1">
              <a:avLst/>
            </a:prstGeom>
            <a:ln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134">
              <a:extLst>
                <a:ext uri="{FF2B5EF4-FFF2-40B4-BE49-F238E27FC236}">
                  <a16:creationId xmlns:a16="http://schemas.microsoft.com/office/drawing/2014/main" id="{53669954-2D5E-0B74-7F7D-C5FA3F2526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739196">
              <a:off x="6435620" y="4357556"/>
              <a:ext cx="84029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4, IL-13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cxnSp>
          <p:nvCxnSpPr>
            <p:cNvPr id="58" name="Straight Connector 4">
              <a:extLst>
                <a:ext uri="{FF2B5EF4-FFF2-40B4-BE49-F238E27FC236}">
                  <a16:creationId xmlns:a16="http://schemas.microsoft.com/office/drawing/2014/main" id="{0477CDB4-D845-D505-0456-A7AE10F60AD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4440426" y="5309652"/>
              <a:ext cx="650801" cy="0"/>
            </a:xfrm>
            <a:prstGeom prst="line">
              <a:avLst/>
            </a:prstGeom>
            <a:ln w="12700"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68">
              <a:extLst>
                <a:ext uri="{FF2B5EF4-FFF2-40B4-BE49-F238E27FC236}">
                  <a16:creationId xmlns:a16="http://schemas.microsoft.com/office/drawing/2014/main" id="{7FB0ACFB-D3B5-1669-4C02-42A548F35E6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8750734" y="2728709"/>
              <a:ext cx="6560" cy="319502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0" name="Straight Connector 68">
              <a:extLst>
                <a:ext uri="{FF2B5EF4-FFF2-40B4-BE49-F238E27FC236}">
                  <a16:creationId xmlns:a16="http://schemas.microsoft.com/office/drawing/2014/main" id="{8B0B45E3-7D1C-A449-295B-56865A0E8B0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8757294" y="3841497"/>
              <a:ext cx="6560" cy="319502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1" name="Straight Connector 68">
              <a:extLst>
                <a:ext uri="{FF2B5EF4-FFF2-40B4-BE49-F238E27FC236}">
                  <a16:creationId xmlns:a16="http://schemas.microsoft.com/office/drawing/2014/main" id="{7A96EB82-34A4-205A-B760-E0A15BEFB05A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8772697" y="4909755"/>
              <a:ext cx="6560" cy="319502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2" name="Straight Connector 68">
              <a:extLst>
                <a:ext uri="{FF2B5EF4-FFF2-40B4-BE49-F238E27FC236}">
                  <a16:creationId xmlns:a16="http://schemas.microsoft.com/office/drawing/2014/main" id="{3BC05F9F-DBF6-0EF3-9A0D-53429BE33F1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8698249" y="1615961"/>
              <a:ext cx="6560" cy="319502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3" name="Straight Connector 68">
              <a:extLst>
                <a:ext uri="{FF2B5EF4-FFF2-40B4-BE49-F238E27FC236}">
                  <a16:creationId xmlns:a16="http://schemas.microsoft.com/office/drawing/2014/main" id="{7049D530-B51B-782B-832E-94DB7922575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933546" y="3915629"/>
              <a:ext cx="179963" cy="269837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A64A2F20-D9DB-D76F-119E-5332F85C1315}"/>
                </a:ext>
              </a:extLst>
            </p:cNvPr>
            <p:cNvCxnSpPr>
              <a:cxnSpLocks/>
              <a:endCxn id="77" idx="1"/>
            </p:cNvCxnSpPr>
            <p:nvPr/>
          </p:nvCxnSpPr>
          <p:spPr>
            <a:xfrm flipH="1">
              <a:off x="8801209" y="3481398"/>
              <a:ext cx="1107178" cy="526505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4593DC06-8CA5-A306-3311-6D5B98B0BEE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758098" y="2900161"/>
              <a:ext cx="1091035" cy="17303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F3642A92-19C1-4609-763F-3CD4F4C2AED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79257" y="3622307"/>
              <a:ext cx="1318376" cy="147190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C401CC75-34E9-DDED-1894-5241E6D5AD19}"/>
                </a:ext>
              </a:extLst>
            </p:cNvPr>
            <p:cNvCxnSpPr>
              <a:cxnSpLocks/>
            </p:cNvCxnSpPr>
            <p:nvPr/>
          </p:nvCxnSpPr>
          <p:spPr>
            <a:xfrm>
              <a:off x="8719517" y="1775712"/>
              <a:ext cx="1227143" cy="98659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Arrow Connector 67">
              <a:extLst>
                <a:ext uri="{FF2B5EF4-FFF2-40B4-BE49-F238E27FC236}">
                  <a16:creationId xmlns:a16="http://schemas.microsoft.com/office/drawing/2014/main" id="{5AB05141-CCF1-458C-DC11-84C1FD0A860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68625" y="5210879"/>
              <a:ext cx="1179712" cy="27257"/>
            </a:xfrm>
            <a:prstGeom prst="straightConnector1">
              <a:avLst/>
            </a:prstGeom>
            <a:ln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164">
              <a:extLst>
                <a:ext uri="{FF2B5EF4-FFF2-40B4-BE49-F238E27FC236}">
                  <a16:creationId xmlns:a16="http://schemas.microsoft.com/office/drawing/2014/main" id="{DE8469CE-1CC8-EE37-4741-34C2494629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63543" y="5231959"/>
              <a:ext cx="43473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4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71269E7B-9C00-3A32-3320-51FD400F25E7}"/>
                </a:ext>
              </a:extLst>
            </p:cNvPr>
            <p:cNvCxnSpPr>
              <a:cxnSpLocks/>
              <a:stCxn id="109" idx="0"/>
            </p:cNvCxnSpPr>
            <p:nvPr/>
          </p:nvCxnSpPr>
          <p:spPr>
            <a:xfrm flipV="1">
              <a:off x="5681980" y="4227946"/>
              <a:ext cx="885" cy="58384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D85C7F90-E19B-5B36-C50C-9796BE14CF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77880" y="4048067"/>
              <a:ext cx="828561" cy="78167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125">
              <a:extLst>
                <a:ext uri="{FF2B5EF4-FFF2-40B4-BE49-F238E27FC236}">
                  <a16:creationId xmlns:a16="http://schemas.microsoft.com/office/drawing/2014/main" id="{ADEEC570-B43C-C878-DE9D-80D7D17491C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7103">
              <a:off x="8790259" y="4552189"/>
              <a:ext cx="542925" cy="431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10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 err="1">
                  <a:solidFill>
                    <a:srgbClr val="003399"/>
                  </a:solidFill>
                </a:rPr>
                <a:t>TGF</a:t>
              </a:r>
              <a:r>
                <a:rPr lang="en-US" altLang="en-US" sz="1100" b="1" dirty="0" err="1">
                  <a:solidFill>
                    <a:srgbClr val="003399"/>
                  </a:solidFill>
                  <a:latin typeface="Symbol" panose="05050102010706020507" pitchFamily="18" charset="2"/>
                </a:rPr>
                <a:t>b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sp>
          <p:nvSpPr>
            <p:cNvPr id="73" name="TextBox 125">
              <a:extLst>
                <a:ext uri="{FF2B5EF4-FFF2-40B4-BE49-F238E27FC236}">
                  <a16:creationId xmlns:a16="http://schemas.microsoft.com/office/drawing/2014/main" id="{9B7CA3A0-EFE4-3213-6523-4D2BCA07BB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592967">
              <a:off x="8845456" y="1916004"/>
              <a:ext cx="542925" cy="431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10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 err="1">
                  <a:solidFill>
                    <a:srgbClr val="003399"/>
                  </a:solidFill>
                </a:rPr>
                <a:t>TGF</a:t>
              </a:r>
              <a:r>
                <a:rPr lang="en-US" altLang="en-US" sz="1100" b="1" dirty="0" err="1">
                  <a:solidFill>
                    <a:srgbClr val="003399"/>
                  </a:solidFill>
                  <a:latin typeface="Symbol" panose="05050102010706020507" pitchFamily="18" charset="2"/>
                </a:rPr>
                <a:t>b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cxnSp>
          <p:nvCxnSpPr>
            <p:cNvPr id="74" name="Straight Arrow Connector 73">
              <a:extLst>
                <a:ext uri="{FF2B5EF4-FFF2-40B4-BE49-F238E27FC236}">
                  <a16:creationId xmlns:a16="http://schemas.microsoft.com/office/drawing/2014/main" id="{44E9CBA4-99DA-CAA5-644A-BA73C7CDB3CA}"/>
                </a:ext>
              </a:extLst>
            </p:cNvPr>
            <p:cNvCxnSpPr>
              <a:cxnSpLocks/>
              <a:endCxn id="33" idx="17"/>
            </p:cNvCxnSpPr>
            <p:nvPr/>
          </p:nvCxnSpPr>
          <p:spPr>
            <a:xfrm flipV="1">
              <a:off x="6259707" y="3139899"/>
              <a:ext cx="1224919" cy="563515"/>
            </a:xfrm>
            <a:prstGeom prst="straightConnector1">
              <a:avLst/>
            </a:prstGeom>
            <a:ln w="12700"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112">
              <a:extLst>
                <a:ext uri="{FF2B5EF4-FFF2-40B4-BE49-F238E27FC236}">
                  <a16:creationId xmlns:a16="http://schemas.microsoft.com/office/drawing/2014/main" id="{293BA459-F6D8-DF3B-DA75-B9FB806812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54911" y="3908750"/>
              <a:ext cx="426720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5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C774558E-9ED6-1868-2624-9787D87D3F90}"/>
                </a:ext>
              </a:extLst>
            </p:cNvPr>
            <p:cNvCxnSpPr>
              <a:stCxn id="28" idx="2"/>
            </p:cNvCxnSpPr>
            <p:nvPr/>
          </p:nvCxnSpPr>
          <p:spPr>
            <a:xfrm flipH="1">
              <a:off x="1981357" y="2809852"/>
              <a:ext cx="22439" cy="346931"/>
            </a:xfrm>
            <a:prstGeom prst="straightConnector1">
              <a:avLst/>
            </a:prstGeom>
            <a:ln w="12700"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125">
              <a:extLst>
                <a:ext uri="{FF2B5EF4-FFF2-40B4-BE49-F238E27FC236}">
                  <a16:creationId xmlns:a16="http://schemas.microsoft.com/office/drawing/2014/main" id="{C7016967-50CC-2669-B5DB-2EBF9009AD3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0027900">
              <a:off x="8773315" y="3672144"/>
              <a:ext cx="542925" cy="431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10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 err="1">
                  <a:solidFill>
                    <a:srgbClr val="003399"/>
                  </a:solidFill>
                </a:rPr>
                <a:t>TGF</a:t>
              </a:r>
              <a:r>
                <a:rPr lang="en-US" altLang="en-US" sz="1100" b="1" dirty="0" err="1">
                  <a:solidFill>
                    <a:srgbClr val="003399"/>
                  </a:solidFill>
                  <a:latin typeface="Symbol" panose="05050102010706020507" pitchFamily="18" charset="2"/>
                </a:rPr>
                <a:t>b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sp>
          <p:nvSpPr>
            <p:cNvPr id="78" name="Rectangle: Rounded Corners 113">
              <a:extLst>
                <a:ext uri="{FF2B5EF4-FFF2-40B4-BE49-F238E27FC236}">
                  <a16:creationId xmlns:a16="http://schemas.microsoft.com/office/drawing/2014/main" id="{3F242B0C-C705-27F2-CEE4-F369F4CBBA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42888" y="1134006"/>
              <a:ext cx="693941" cy="392505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12700" algn="ctr">
              <a:solidFill>
                <a:srgbClr val="FFC000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79" name="Rectangle: Rounded Corners 114">
              <a:extLst>
                <a:ext uri="{FF2B5EF4-FFF2-40B4-BE49-F238E27FC236}">
                  <a16:creationId xmlns:a16="http://schemas.microsoft.com/office/drawing/2014/main" id="{953EB19F-F3D7-59B3-77BB-012B4067B6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0624" y="1526511"/>
              <a:ext cx="693941" cy="392505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12700" algn="ctr">
              <a:solidFill>
                <a:srgbClr val="FFC000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cxnSp>
          <p:nvCxnSpPr>
            <p:cNvPr id="80" name="Straight Connector 116">
              <a:extLst>
                <a:ext uri="{FF2B5EF4-FFF2-40B4-BE49-F238E27FC236}">
                  <a16:creationId xmlns:a16="http://schemas.microsoft.com/office/drawing/2014/main" id="{F8C0D285-79CA-E529-D8EB-50E2B4F181B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7362356" y="1196047"/>
              <a:ext cx="280533" cy="19357"/>
            </a:xfrm>
            <a:prstGeom prst="line">
              <a:avLst/>
            </a:prstGeom>
            <a:noFill/>
            <a:ln w="12700" algn="ctr">
              <a:solidFill>
                <a:srgbClr val="FFC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1" name="Straight Connector 118">
              <a:extLst>
                <a:ext uri="{FF2B5EF4-FFF2-40B4-BE49-F238E27FC236}">
                  <a16:creationId xmlns:a16="http://schemas.microsoft.com/office/drawing/2014/main" id="{9A8B2129-02C2-4F34-F874-7EA207B2E3E8}"/>
                </a:ext>
              </a:extLst>
            </p:cNvPr>
            <p:cNvCxnSpPr>
              <a:cxnSpLocks noChangeShapeType="1"/>
              <a:endCxn id="78" idx="1"/>
            </p:cNvCxnSpPr>
            <p:nvPr/>
          </p:nvCxnSpPr>
          <p:spPr bwMode="auto">
            <a:xfrm>
              <a:off x="7311627" y="1312078"/>
              <a:ext cx="331261" cy="18180"/>
            </a:xfrm>
            <a:prstGeom prst="line">
              <a:avLst/>
            </a:prstGeom>
            <a:noFill/>
            <a:ln w="12700" algn="ctr">
              <a:solidFill>
                <a:srgbClr val="FFC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82" name="Straight Connector 120">
              <a:extLst>
                <a:ext uri="{FF2B5EF4-FFF2-40B4-BE49-F238E27FC236}">
                  <a16:creationId xmlns:a16="http://schemas.microsoft.com/office/drawing/2014/main" id="{5D68F9E8-4360-7878-099D-5CB1748251C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7311627" y="1419077"/>
              <a:ext cx="320053" cy="25079"/>
            </a:xfrm>
            <a:prstGeom prst="line">
              <a:avLst/>
            </a:prstGeom>
            <a:noFill/>
            <a:ln w="12700" algn="ctr">
              <a:solidFill>
                <a:srgbClr val="FFC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83" name="Oval 155">
              <a:extLst>
                <a:ext uri="{FF2B5EF4-FFF2-40B4-BE49-F238E27FC236}">
                  <a16:creationId xmlns:a16="http://schemas.microsoft.com/office/drawing/2014/main" id="{18174018-84FD-5603-2DBD-CA68ADA71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98771" y="1269471"/>
              <a:ext cx="402853" cy="174686"/>
            </a:xfrm>
            <a:prstGeom prst="ellipse">
              <a:avLst/>
            </a:prstGeom>
            <a:solidFill>
              <a:srgbClr val="7030A0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84" name="Oval 155">
              <a:extLst>
                <a:ext uri="{FF2B5EF4-FFF2-40B4-BE49-F238E27FC236}">
                  <a16:creationId xmlns:a16="http://schemas.microsoft.com/office/drawing/2014/main" id="{1E5FDCCE-0416-D2AB-F7A0-FA2D245842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05135" y="1627469"/>
              <a:ext cx="402853" cy="174686"/>
            </a:xfrm>
            <a:prstGeom prst="ellipse">
              <a:avLst/>
            </a:prstGeom>
            <a:solidFill>
              <a:srgbClr val="7030A0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85" name="Freeform: Shape 84">
              <a:extLst>
                <a:ext uri="{FF2B5EF4-FFF2-40B4-BE49-F238E27FC236}">
                  <a16:creationId xmlns:a16="http://schemas.microsoft.com/office/drawing/2014/main" id="{EC2C6899-5C43-C7FE-5DCF-CA6421B4F817}"/>
                </a:ext>
              </a:extLst>
            </p:cNvPr>
            <p:cNvSpPr/>
            <p:nvPr/>
          </p:nvSpPr>
          <p:spPr>
            <a:xfrm>
              <a:off x="7200086" y="1595541"/>
              <a:ext cx="464569" cy="421999"/>
            </a:xfrm>
            <a:custGeom>
              <a:avLst/>
              <a:gdLst>
                <a:gd name="connsiteX0" fmla="*/ 353359 w 464569"/>
                <a:gd name="connsiteY0" fmla="*/ 284205 h 421999"/>
                <a:gd name="connsiteX1" fmla="*/ 415142 w 464569"/>
                <a:gd name="connsiteY1" fmla="*/ 247135 h 421999"/>
                <a:gd name="connsiteX2" fmla="*/ 464569 w 464569"/>
                <a:gd name="connsiteY2" fmla="*/ 148281 h 421999"/>
                <a:gd name="connsiteX3" fmla="*/ 439856 w 464569"/>
                <a:gd name="connsiteY3" fmla="*/ 74140 h 421999"/>
                <a:gd name="connsiteX4" fmla="*/ 229791 w 464569"/>
                <a:gd name="connsiteY4" fmla="*/ 86497 h 421999"/>
                <a:gd name="connsiteX5" fmla="*/ 192721 w 464569"/>
                <a:gd name="connsiteY5" fmla="*/ 111211 h 421999"/>
                <a:gd name="connsiteX6" fmla="*/ 254505 w 464569"/>
                <a:gd name="connsiteY6" fmla="*/ 185351 h 421999"/>
                <a:gd name="connsiteX7" fmla="*/ 316288 w 464569"/>
                <a:gd name="connsiteY7" fmla="*/ 222422 h 421999"/>
                <a:gd name="connsiteX8" fmla="*/ 378072 w 464569"/>
                <a:gd name="connsiteY8" fmla="*/ 197708 h 421999"/>
                <a:gd name="connsiteX9" fmla="*/ 402786 w 464569"/>
                <a:gd name="connsiteY9" fmla="*/ 148281 h 421999"/>
                <a:gd name="connsiteX10" fmla="*/ 341002 w 464569"/>
                <a:gd name="connsiteY10" fmla="*/ 74140 h 421999"/>
                <a:gd name="connsiteX11" fmla="*/ 328645 w 464569"/>
                <a:gd name="connsiteY11" fmla="*/ 37070 h 421999"/>
                <a:gd name="connsiteX12" fmla="*/ 205077 w 464569"/>
                <a:gd name="connsiteY12" fmla="*/ 0 h 421999"/>
                <a:gd name="connsiteX13" fmla="*/ 81510 w 464569"/>
                <a:gd name="connsiteY13" fmla="*/ 12357 h 421999"/>
                <a:gd name="connsiteX14" fmla="*/ 44440 w 464569"/>
                <a:gd name="connsiteY14" fmla="*/ 271849 h 421999"/>
                <a:gd name="connsiteX15" fmla="*/ 130937 w 464569"/>
                <a:gd name="connsiteY15" fmla="*/ 296562 h 421999"/>
                <a:gd name="connsiteX16" fmla="*/ 180364 w 464569"/>
                <a:gd name="connsiteY16" fmla="*/ 284205 h 421999"/>
                <a:gd name="connsiteX17" fmla="*/ 192721 w 464569"/>
                <a:gd name="connsiteY17" fmla="*/ 234778 h 421999"/>
                <a:gd name="connsiteX18" fmla="*/ 81510 w 464569"/>
                <a:gd name="connsiteY18" fmla="*/ 197708 h 421999"/>
                <a:gd name="connsiteX19" fmla="*/ 44440 w 464569"/>
                <a:gd name="connsiteY19" fmla="*/ 345989 h 421999"/>
                <a:gd name="connsiteX20" fmla="*/ 205077 w 464569"/>
                <a:gd name="connsiteY20" fmla="*/ 395416 h 421999"/>
                <a:gd name="connsiteX21" fmla="*/ 242148 w 464569"/>
                <a:gd name="connsiteY21" fmla="*/ 420130 h 421999"/>
                <a:gd name="connsiteX22" fmla="*/ 254505 w 464569"/>
                <a:gd name="connsiteY22" fmla="*/ 358346 h 421999"/>
                <a:gd name="connsiteX23" fmla="*/ 279218 w 464569"/>
                <a:gd name="connsiteY23" fmla="*/ 185351 h 421999"/>
                <a:gd name="connsiteX24" fmla="*/ 353359 w 464569"/>
                <a:gd name="connsiteY24" fmla="*/ 210065 h 421999"/>
                <a:gd name="connsiteX25" fmla="*/ 402786 w 464569"/>
                <a:gd name="connsiteY25" fmla="*/ 222422 h 421999"/>
                <a:gd name="connsiteX26" fmla="*/ 415142 w 464569"/>
                <a:gd name="connsiteY26" fmla="*/ 247135 h 4219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</a:cxnLst>
              <a:rect l="l" t="t" r="r" b="b"/>
              <a:pathLst>
                <a:path w="464569" h="421999">
                  <a:moveTo>
                    <a:pt x="353359" y="284205"/>
                  </a:moveTo>
                  <a:cubicBezTo>
                    <a:pt x="373953" y="271848"/>
                    <a:pt x="396907" y="262765"/>
                    <a:pt x="415142" y="247135"/>
                  </a:cubicBezTo>
                  <a:cubicBezTo>
                    <a:pt x="437676" y="227820"/>
                    <a:pt x="455973" y="169770"/>
                    <a:pt x="464569" y="148281"/>
                  </a:cubicBezTo>
                  <a:cubicBezTo>
                    <a:pt x="456331" y="123567"/>
                    <a:pt x="461834" y="88126"/>
                    <a:pt x="439856" y="74140"/>
                  </a:cubicBezTo>
                  <a:cubicBezTo>
                    <a:pt x="380796" y="36557"/>
                    <a:pt x="286598" y="72296"/>
                    <a:pt x="229791" y="86497"/>
                  </a:cubicBezTo>
                  <a:cubicBezTo>
                    <a:pt x="217434" y="94735"/>
                    <a:pt x="200959" y="98854"/>
                    <a:pt x="192721" y="111211"/>
                  </a:cubicBezTo>
                  <a:cubicBezTo>
                    <a:pt x="146511" y="180527"/>
                    <a:pt x="206490" y="163526"/>
                    <a:pt x="254505" y="185351"/>
                  </a:cubicBezTo>
                  <a:cubicBezTo>
                    <a:pt x="276369" y="195289"/>
                    <a:pt x="295694" y="210065"/>
                    <a:pt x="316288" y="222422"/>
                  </a:cubicBezTo>
                  <a:cubicBezTo>
                    <a:pt x="336883" y="214184"/>
                    <a:pt x="361231" y="212143"/>
                    <a:pt x="378072" y="197708"/>
                  </a:cubicBezTo>
                  <a:cubicBezTo>
                    <a:pt x="392058" y="185720"/>
                    <a:pt x="402786" y="166701"/>
                    <a:pt x="402786" y="148281"/>
                  </a:cubicBezTo>
                  <a:cubicBezTo>
                    <a:pt x="402786" y="131079"/>
                    <a:pt x="348085" y="81224"/>
                    <a:pt x="341002" y="74140"/>
                  </a:cubicBezTo>
                  <a:cubicBezTo>
                    <a:pt x="336883" y="61783"/>
                    <a:pt x="337855" y="46280"/>
                    <a:pt x="328645" y="37070"/>
                  </a:cubicBezTo>
                  <a:cubicBezTo>
                    <a:pt x="299911" y="8336"/>
                    <a:pt x="238761" y="5614"/>
                    <a:pt x="205077" y="0"/>
                  </a:cubicBezTo>
                  <a:cubicBezTo>
                    <a:pt x="163888" y="4119"/>
                    <a:pt x="120493" y="-1566"/>
                    <a:pt x="81510" y="12357"/>
                  </a:cubicBezTo>
                  <a:cubicBezTo>
                    <a:pt x="-16410" y="47329"/>
                    <a:pt x="27388" y="231351"/>
                    <a:pt x="44440" y="271849"/>
                  </a:cubicBezTo>
                  <a:cubicBezTo>
                    <a:pt x="56076" y="299485"/>
                    <a:pt x="102105" y="288324"/>
                    <a:pt x="130937" y="296562"/>
                  </a:cubicBezTo>
                  <a:cubicBezTo>
                    <a:pt x="147413" y="292443"/>
                    <a:pt x="168355" y="296214"/>
                    <a:pt x="180364" y="284205"/>
                  </a:cubicBezTo>
                  <a:cubicBezTo>
                    <a:pt x="192373" y="272196"/>
                    <a:pt x="200316" y="249968"/>
                    <a:pt x="192721" y="234778"/>
                  </a:cubicBezTo>
                  <a:cubicBezTo>
                    <a:pt x="181353" y="212042"/>
                    <a:pt x="96544" y="200715"/>
                    <a:pt x="81510" y="197708"/>
                  </a:cubicBezTo>
                  <a:cubicBezTo>
                    <a:pt x="10311" y="226188"/>
                    <a:pt x="-40650" y="223082"/>
                    <a:pt x="44440" y="345989"/>
                  </a:cubicBezTo>
                  <a:cubicBezTo>
                    <a:pt x="66889" y="378415"/>
                    <a:pt x="169543" y="389494"/>
                    <a:pt x="205077" y="395416"/>
                  </a:cubicBezTo>
                  <a:cubicBezTo>
                    <a:pt x="217434" y="403654"/>
                    <a:pt x="230267" y="429041"/>
                    <a:pt x="242148" y="420130"/>
                  </a:cubicBezTo>
                  <a:cubicBezTo>
                    <a:pt x="258950" y="407529"/>
                    <a:pt x="251900" y="379186"/>
                    <a:pt x="254505" y="358346"/>
                  </a:cubicBezTo>
                  <a:cubicBezTo>
                    <a:pt x="276162" y="185084"/>
                    <a:pt x="250149" y="272558"/>
                    <a:pt x="279218" y="185351"/>
                  </a:cubicBezTo>
                  <a:cubicBezTo>
                    <a:pt x="303932" y="193589"/>
                    <a:pt x="328407" y="202579"/>
                    <a:pt x="353359" y="210065"/>
                  </a:cubicBezTo>
                  <a:cubicBezTo>
                    <a:pt x="369626" y="214945"/>
                    <a:pt x="388223" y="213684"/>
                    <a:pt x="402786" y="222422"/>
                  </a:cubicBezTo>
                  <a:cubicBezTo>
                    <a:pt x="410683" y="227160"/>
                    <a:pt x="411023" y="238897"/>
                    <a:pt x="415142" y="247135"/>
                  </a:cubicBezTo>
                </a:path>
              </a:pathLst>
            </a:custGeom>
            <a:solidFill>
              <a:srgbClr val="FFFF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FF9FE76-148B-0A89-EE31-968880AEFD19}"/>
                </a:ext>
              </a:extLst>
            </p:cNvPr>
            <p:cNvSpPr txBox="1"/>
            <p:nvPr/>
          </p:nvSpPr>
          <p:spPr>
            <a:xfrm>
              <a:off x="7556025" y="1907315"/>
              <a:ext cx="10823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pithelial cell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896834C7-8E44-8A28-4507-5845C1686EF4}"/>
                </a:ext>
              </a:extLst>
            </p:cNvPr>
            <p:cNvSpPr txBox="1"/>
            <p:nvPr/>
          </p:nvSpPr>
          <p:spPr>
            <a:xfrm>
              <a:off x="6670430" y="1514102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ucus</a:t>
              </a:r>
            </a:p>
          </p:txBody>
        </p:sp>
        <p:cxnSp>
          <p:nvCxnSpPr>
            <p:cNvPr id="88" name="Straight Arrow Connector 87">
              <a:extLst>
                <a:ext uri="{FF2B5EF4-FFF2-40B4-BE49-F238E27FC236}">
                  <a16:creationId xmlns:a16="http://schemas.microsoft.com/office/drawing/2014/main" id="{84E50AFE-DB59-5CD1-17CC-DEBF231A5AE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6988" y="1964511"/>
              <a:ext cx="1109812" cy="1298236"/>
            </a:xfrm>
            <a:prstGeom prst="straightConnector1">
              <a:avLst/>
            </a:prstGeom>
            <a:ln w="12700"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134">
              <a:extLst>
                <a:ext uri="{FF2B5EF4-FFF2-40B4-BE49-F238E27FC236}">
                  <a16:creationId xmlns:a16="http://schemas.microsoft.com/office/drawing/2014/main" id="{8B6A3066-2D6D-541F-3F5A-3DD4545A26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610382">
              <a:off x="5901385" y="2537231"/>
              <a:ext cx="84029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L-4, IL-13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75B89351-0C7A-0D8C-5DEF-FB0899472A3A}"/>
                </a:ext>
              </a:extLst>
            </p:cNvPr>
            <p:cNvGrpSpPr/>
            <p:nvPr/>
          </p:nvGrpSpPr>
          <p:grpSpPr>
            <a:xfrm>
              <a:off x="8567854" y="5796459"/>
              <a:ext cx="182880" cy="228600"/>
              <a:chOff x="2722617" y="6133125"/>
              <a:chExt cx="137160" cy="258193"/>
            </a:xfrm>
            <a:solidFill>
              <a:srgbClr val="FF9900"/>
            </a:solidFill>
          </p:grpSpPr>
          <p:sp>
            <p:nvSpPr>
              <p:cNvPr id="105" name="Arrow: Chevron 104">
                <a:extLst>
                  <a:ext uri="{FF2B5EF4-FFF2-40B4-BE49-F238E27FC236}">
                    <a16:creationId xmlns:a16="http://schemas.microsoft.com/office/drawing/2014/main" id="{4BEDF25F-9C95-6CDC-050B-626B4FA62D73}"/>
                  </a:ext>
                </a:extLst>
              </p:cNvPr>
              <p:cNvSpPr/>
              <p:nvPr/>
            </p:nvSpPr>
            <p:spPr>
              <a:xfrm rot="5569963">
                <a:off x="2722617" y="6133125"/>
                <a:ext cx="137160" cy="137160"/>
              </a:xfrm>
              <a:prstGeom prst="chevron">
                <a:avLst/>
              </a:prstGeom>
              <a:grp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id="{DB1D4035-D900-E799-FB29-C9D43B63874B}"/>
                  </a:ext>
                </a:extLst>
              </p:cNvPr>
              <p:cNvSpPr/>
              <p:nvPr/>
            </p:nvSpPr>
            <p:spPr>
              <a:xfrm>
                <a:off x="2768337" y="6250275"/>
                <a:ext cx="45719" cy="141043"/>
              </a:xfrm>
              <a:prstGeom prst="rect">
                <a:avLst/>
              </a:prstGeom>
              <a:grp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2"/>
              </a:p>
            </p:txBody>
          </p:sp>
        </p:grpSp>
        <p:cxnSp>
          <p:nvCxnSpPr>
            <p:cNvPr id="91" name="Straight Arrow Connector 90">
              <a:extLst>
                <a:ext uri="{FF2B5EF4-FFF2-40B4-BE49-F238E27FC236}">
                  <a16:creationId xmlns:a16="http://schemas.microsoft.com/office/drawing/2014/main" id="{5063506E-1A9D-FBC6-3927-518B2A2E5AA4}"/>
                </a:ext>
              </a:extLst>
            </p:cNvPr>
            <p:cNvCxnSpPr>
              <a:cxnSpLocks/>
            </p:cNvCxnSpPr>
            <p:nvPr/>
          </p:nvCxnSpPr>
          <p:spPr>
            <a:xfrm>
              <a:off x="8327594" y="5676119"/>
              <a:ext cx="160527" cy="234640"/>
            </a:xfrm>
            <a:prstGeom prst="straightConnector1">
              <a:avLst/>
            </a:prstGeom>
            <a:ln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2" name="Group 91">
              <a:extLst>
                <a:ext uri="{FF2B5EF4-FFF2-40B4-BE49-F238E27FC236}">
                  <a16:creationId xmlns:a16="http://schemas.microsoft.com/office/drawing/2014/main" id="{1DCE6B4A-79EC-C225-C2EC-88A6E70C574A}"/>
                </a:ext>
              </a:extLst>
            </p:cNvPr>
            <p:cNvGrpSpPr/>
            <p:nvPr/>
          </p:nvGrpSpPr>
          <p:grpSpPr>
            <a:xfrm>
              <a:off x="8361575" y="2462927"/>
              <a:ext cx="182880" cy="228600"/>
              <a:chOff x="2722617" y="6133125"/>
              <a:chExt cx="137160" cy="258193"/>
            </a:xfrm>
            <a:solidFill>
              <a:srgbClr val="FF9900"/>
            </a:solidFill>
          </p:grpSpPr>
          <p:sp>
            <p:nvSpPr>
              <p:cNvPr id="103" name="Arrow: Chevron 102">
                <a:extLst>
                  <a:ext uri="{FF2B5EF4-FFF2-40B4-BE49-F238E27FC236}">
                    <a16:creationId xmlns:a16="http://schemas.microsoft.com/office/drawing/2014/main" id="{0D5F6CB0-A6ED-7E82-727C-30D9E3DB96BE}"/>
                  </a:ext>
                </a:extLst>
              </p:cNvPr>
              <p:cNvSpPr/>
              <p:nvPr/>
            </p:nvSpPr>
            <p:spPr>
              <a:xfrm rot="5569963">
                <a:off x="2722617" y="6133125"/>
                <a:ext cx="137160" cy="137160"/>
              </a:xfrm>
              <a:prstGeom prst="chevron">
                <a:avLst/>
              </a:prstGeom>
              <a:grp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2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04" name="Rectangle 103">
                <a:extLst>
                  <a:ext uri="{FF2B5EF4-FFF2-40B4-BE49-F238E27FC236}">
                    <a16:creationId xmlns:a16="http://schemas.microsoft.com/office/drawing/2014/main" id="{5C8844CF-A0B3-BB33-E756-D80190579AAB}"/>
                  </a:ext>
                </a:extLst>
              </p:cNvPr>
              <p:cNvSpPr/>
              <p:nvPr/>
            </p:nvSpPr>
            <p:spPr>
              <a:xfrm>
                <a:off x="2768337" y="6250275"/>
                <a:ext cx="45719" cy="141043"/>
              </a:xfrm>
              <a:prstGeom prst="rect">
                <a:avLst/>
              </a:prstGeom>
              <a:grp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2"/>
              </a:p>
            </p:txBody>
          </p:sp>
        </p:grpSp>
        <p:sp>
          <p:nvSpPr>
            <p:cNvPr id="93" name="TextBox 112">
              <a:extLst>
                <a:ext uri="{FF2B5EF4-FFF2-40B4-BE49-F238E27FC236}">
                  <a16:creationId xmlns:a16="http://schemas.microsoft.com/office/drawing/2014/main" id="{997E8ECA-C65B-96F6-27A2-E0245A940D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1430081">
              <a:off x="8704586" y="5729507"/>
              <a:ext cx="497252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gG1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>
                  <a:solidFill>
                    <a:srgbClr val="003399"/>
                  </a:solidFill>
                </a:rPr>
                <a:t>IgE</a:t>
              </a:r>
              <a:endParaRPr lang="en-US" altLang="en-US" sz="1100" b="1" dirty="0">
                <a:solidFill>
                  <a:srgbClr val="003399"/>
                </a:solidFill>
                <a:latin typeface="Symbol" panose="05050102010706020507" pitchFamily="18" charset="2"/>
              </a:endParaRPr>
            </a:p>
          </p:txBody>
        </p:sp>
        <p:sp>
          <p:nvSpPr>
            <p:cNvPr id="94" name="Oval 157">
              <a:extLst>
                <a:ext uri="{FF2B5EF4-FFF2-40B4-BE49-F238E27FC236}">
                  <a16:creationId xmlns:a16="http://schemas.microsoft.com/office/drawing/2014/main" id="{4C1352BA-FC74-730B-5877-45507FC38B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21654" y="3216918"/>
              <a:ext cx="73599" cy="61915"/>
            </a:xfrm>
            <a:prstGeom prst="ellipse">
              <a:avLst/>
            </a:prstGeom>
            <a:solidFill>
              <a:srgbClr val="003399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95" name="Oval 157">
              <a:extLst>
                <a:ext uri="{FF2B5EF4-FFF2-40B4-BE49-F238E27FC236}">
                  <a16:creationId xmlns:a16="http://schemas.microsoft.com/office/drawing/2014/main" id="{6BE83764-E462-874C-988B-B63986557B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5573" y="2826545"/>
              <a:ext cx="73599" cy="61915"/>
            </a:xfrm>
            <a:prstGeom prst="ellipse">
              <a:avLst/>
            </a:prstGeom>
            <a:solidFill>
              <a:srgbClr val="003399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96" name="Oval 157">
              <a:extLst>
                <a:ext uri="{FF2B5EF4-FFF2-40B4-BE49-F238E27FC236}">
                  <a16:creationId xmlns:a16="http://schemas.microsoft.com/office/drawing/2014/main" id="{11E71F8E-158A-228A-93EB-C92F54C880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69078" y="3211800"/>
              <a:ext cx="73599" cy="61915"/>
            </a:xfrm>
            <a:prstGeom prst="ellipse">
              <a:avLst/>
            </a:prstGeom>
            <a:solidFill>
              <a:srgbClr val="003399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97" name="Oval 157">
              <a:extLst>
                <a:ext uri="{FF2B5EF4-FFF2-40B4-BE49-F238E27FC236}">
                  <a16:creationId xmlns:a16="http://schemas.microsoft.com/office/drawing/2014/main" id="{B0F9E288-22C6-EB9B-03D5-8549F440EC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41789" y="2871566"/>
              <a:ext cx="73599" cy="61915"/>
            </a:xfrm>
            <a:prstGeom prst="ellipse">
              <a:avLst/>
            </a:prstGeom>
            <a:solidFill>
              <a:srgbClr val="003399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98" name="Oval 157">
              <a:extLst>
                <a:ext uri="{FF2B5EF4-FFF2-40B4-BE49-F238E27FC236}">
                  <a16:creationId xmlns:a16="http://schemas.microsoft.com/office/drawing/2014/main" id="{E039D17B-CB68-4E56-B3C3-3A2361B21E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16259" y="2626726"/>
              <a:ext cx="73599" cy="61915"/>
            </a:xfrm>
            <a:prstGeom prst="ellipse">
              <a:avLst/>
            </a:prstGeom>
            <a:solidFill>
              <a:srgbClr val="003399"/>
            </a:solidFill>
            <a:ln w="12700" algn="ctr">
              <a:solidFill>
                <a:schemeClr val="tx1"/>
              </a:solidFill>
              <a:round/>
              <a:headEnd/>
              <a:tailEnd/>
            </a:ln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99" name="Partial Circle 98">
              <a:extLst>
                <a:ext uri="{FF2B5EF4-FFF2-40B4-BE49-F238E27FC236}">
                  <a16:creationId xmlns:a16="http://schemas.microsoft.com/office/drawing/2014/main" id="{AA5ECA7E-E5EB-332F-85DF-117C9BD2882E}"/>
                </a:ext>
              </a:extLst>
            </p:cNvPr>
            <p:cNvSpPr/>
            <p:nvPr/>
          </p:nvSpPr>
          <p:spPr>
            <a:xfrm rot="19021527">
              <a:off x="4517131" y="1673177"/>
              <a:ext cx="186138" cy="201316"/>
            </a:xfrm>
            <a:prstGeom prst="pie">
              <a:avLst/>
            </a:prstGeom>
            <a:solidFill>
              <a:srgbClr val="FF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00" name="Partial Circle 99">
              <a:extLst>
                <a:ext uri="{FF2B5EF4-FFF2-40B4-BE49-F238E27FC236}">
                  <a16:creationId xmlns:a16="http://schemas.microsoft.com/office/drawing/2014/main" id="{D25B172D-75B5-CA8B-F739-4EF3DD4CF0BD}"/>
                </a:ext>
              </a:extLst>
            </p:cNvPr>
            <p:cNvSpPr/>
            <p:nvPr/>
          </p:nvSpPr>
          <p:spPr>
            <a:xfrm rot="15245353">
              <a:off x="3197013" y="5000444"/>
              <a:ext cx="186138" cy="201316"/>
            </a:xfrm>
            <a:prstGeom prst="pie">
              <a:avLst/>
            </a:prstGeom>
            <a:solidFill>
              <a:srgbClr val="FF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01" name="Partial Circle 100">
              <a:extLst>
                <a:ext uri="{FF2B5EF4-FFF2-40B4-BE49-F238E27FC236}">
                  <a16:creationId xmlns:a16="http://schemas.microsoft.com/office/drawing/2014/main" id="{43F04DD6-CE38-5982-477A-E073BBE7DEE8}"/>
                </a:ext>
              </a:extLst>
            </p:cNvPr>
            <p:cNvSpPr/>
            <p:nvPr/>
          </p:nvSpPr>
          <p:spPr>
            <a:xfrm rot="8846756">
              <a:off x="7729231" y="5601221"/>
              <a:ext cx="186138" cy="201316"/>
            </a:xfrm>
            <a:prstGeom prst="pie">
              <a:avLst/>
            </a:prstGeom>
            <a:solidFill>
              <a:srgbClr val="FF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02" name="TextBox 52">
              <a:extLst>
                <a:ext uri="{FF2B5EF4-FFF2-40B4-BE49-F238E27FC236}">
                  <a16:creationId xmlns:a16="http://schemas.microsoft.com/office/drawing/2014/main" id="{B17FC31A-0D95-DA9F-E551-6088FBF272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11086" y="5168512"/>
              <a:ext cx="87716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cs typeface="Arial" panose="020B0604020202020204" pitchFamily="34" charset="0"/>
                </a:rPr>
                <a:t>Plexin B1</a:t>
              </a:r>
            </a:p>
          </p:txBody>
        </p:sp>
        <p:sp>
          <p:nvSpPr>
            <p:cNvPr id="2" name="Partial Circle 1">
              <a:extLst>
                <a:ext uri="{FF2B5EF4-FFF2-40B4-BE49-F238E27FC236}">
                  <a16:creationId xmlns:a16="http://schemas.microsoft.com/office/drawing/2014/main" id="{951C5DDE-57D1-8009-202E-81EF4BAD54EA}"/>
                </a:ext>
              </a:extLst>
            </p:cNvPr>
            <p:cNvSpPr/>
            <p:nvPr/>
          </p:nvSpPr>
          <p:spPr>
            <a:xfrm rot="354888">
              <a:off x="10753256" y="2687176"/>
              <a:ext cx="186138" cy="201316"/>
            </a:xfrm>
            <a:prstGeom prst="pie">
              <a:avLst/>
            </a:prstGeom>
            <a:solidFill>
              <a:srgbClr val="FF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3" name="Partial Circle 2">
              <a:extLst>
                <a:ext uri="{FF2B5EF4-FFF2-40B4-BE49-F238E27FC236}">
                  <a16:creationId xmlns:a16="http://schemas.microsoft.com/office/drawing/2014/main" id="{1A8724E1-6004-686E-8B7B-2221E62BDC4A}"/>
                </a:ext>
              </a:extLst>
            </p:cNvPr>
            <p:cNvSpPr/>
            <p:nvPr/>
          </p:nvSpPr>
          <p:spPr>
            <a:xfrm rot="15531810">
              <a:off x="7453758" y="1317700"/>
              <a:ext cx="186138" cy="201316"/>
            </a:xfrm>
            <a:prstGeom prst="pie">
              <a:avLst/>
            </a:prstGeom>
            <a:solidFill>
              <a:srgbClr val="FF0066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20" name="Oval 8">
              <a:extLst>
                <a:ext uri="{FF2B5EF4-FFF2-40B4-BE49-F238E27FC236}">
                  <a16:creationId xmlns:a16="http://schemas.microsoft.com/office/drawing/2014/main" id="{DDA460F8-219C-4367-045F-36C60F70F4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6477" y="1865887"/>
              <a:ext cx="959964" cy="914416"/>
            </a:xfrm>
            <a:prstGeom prst="ellipse">
              <a:avLst/>
            </a:prstGeom>
            <a:solidFill>
              <a:srgbClr val="66FF33"/>
            </a:solidFill>
            <a:ln w="12700" algn="ctr">
              <a:solidFill>
                <a:srgbClr val="FF9933"/>
              </a:solidFill>
              <a:round/>
              <a:headEnd/>
              <a:tailEnd/>
            </a:ln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en-US" sz="2400"/>
            </a:p>
          </p:txBody>
        </p:sp>
        <p:sp>
          <p:nvSpPr>
            <p:cNvPr id="121" name="Oval 9">
              <a:extLst>
                <a:ext uri="{FF2B5EF4-FFF2-40B4-BE49-F238E27FC236}">
                  <a16:creationId xmlns:a16="http://schemas.microsoft.com/office/drawing/2014/main" id="{1E0F412B-CBA3-E6AA-FC4E-B7AD9FE259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3140" y="1989277"/>
              <a:ext cx="610887" cy="605909"/>
            </a:xfrm>
            <a:prstGeom prst="ellipse">
              <a:avLst/>
            </a:prstGeom>
            <a:solidFill>
              <a:srgbClr val="FFFF00"/>
            </a:solidFill>
            <a:ln w="12700" algn="ctr">
              <a:solidFill>
                <a:srgbClr val="FF9933"/>
              </a:solidFill>
              <a:round/>
              <a:headEnd/>
              <a:tailEnd/>
            </a:ln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b="1" dirty="0"/>
                <a:t>act      T </a:t>
              </a:r>
            </a:p>
          </p:txBody>
        </p:sp>
        <p:sp>
          <p:nvSpPr>
            <p:cNvPr id="122" name="Isosceles Triangle 121">
              <a:extLst>
                <a:ext uri="{FF2B5EF4-FFF2-40B4-BE49-F238E27FC236}">
                  <a16:creationId xmlns:a16="http://schemas.microsoft.com/office/drawing/2014/main" id="{E044C4FD-B8C1-B4E6-D70B-F89E6B26907B}"/>
                </a:ext>
              </a:extLst>
            </p:cNvPr>
            <p:cNvSpPr/>
            <p:nvPr/>
          </p:nvSpPr>
          <p:spPr>
            <a:xfrm rot="6748745">
              <a:off x="2951102" y="4912315"/>
              <a:ext cx="184149" cy="169940"/>
            </a:xfrm>
            <a:prstGeom prst="triangle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" name="TextBox 52">
              <a:extLst>
                <a:ext uri="{FF2B5EF4-FFF2-40B4-BE49-F238E27FC236}">
                  <a16:creationId xmlns:a16="http://schemas.microsoft.com/office/drawing/2014/main" id="{37EA30D6-F8F1-4AAD-5057-330DDE9681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65010" y="4826636"/>
              <a:ext cx="78899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cs typeface="Arial" panose="020B0604020202020204" pitchFamily="34" charset="0"/>
                </a:rPr>
                <a:t>Sema4A</a:t>
              </a:r>
            </a:p>
          </p:txBody>
        </p:sp>
        <p:cxnSp>
          <p:nvCxnSpPr>
            <p:cNvPr id="132" name="Straight Arrow Connector 131">
              <a:extLst>
                <a:ext uri="{FF2B5EF4-FFF2-40B4-BE49-F238E27FC236}">
                  <a16:creationId xmlns:a16="http://schemas.microsoft.com/office/drawing/2014/main" id="{AC8DD525-5EB9-1697-6B5E-8A7EF1036AC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72947" y="2728709"/>
              <a:ext cx="380193" cy="404942"/>
            </a:xfrm>
            <a:prstGeom prst="straightConnector1">
              <a:avLst/>
            </a:prstGeom>
            <a:ln>
              <a:prstDash val="lgDash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Arrow Connector 134">
              <a:extLst>
                <a:ext uri="{FF2B5EF4-FFF2-40B4-BE49-F238E27FC236}">
                  <a16:creationId xmlns:a16="http://schemas.microsoft.com/office/drawing/2014/main" id="{CF685440-9AC7-3C3F-64BF-258109C3E225}"/>
                </a:ext>
              </a:extLst>
            </p:cNvPr>
            <p:cNvCxnSpPr>
              <a:cxnSpLocks/>
            </p:cNvCxnSpPr>
            <p:nvPr/>
          </p:nvCxnSpPr>
          <p:spPr>
            <a:xfrm>
              <a:off x="5057521" y="2791083"/>
              <a:ext cx="302591" cy="405817"/>
            </a:xfrm>
            <a:prstGeom prst="straightConnector1">
              <a:avLst/>
            </a:prstGeom>
            <a:ln>
              <a:prstDash val="lgDash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87">
              <a:extLst>
                <a:ext uri="{FF2B5EF4-FFF2-40B4-BE49-F238E27FC236}">
                  <a16:creationId xmlns:a16="http://schemas.microsoft.com/office/drawing/2014/main" id="{058D1597-67AE-5951-4EA2-53D42F0DEC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37408" y="3466037"/>
              <a:ext cx="43633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b="1" dirty="0"/>
                <a:t>Th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744855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0F3EC4-3C6F-14D2-4EB5-28F2C313B0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1325079"/>
          </a:xfrm>
        </p:spPr>
        <p:txBody>
          <a:bodyPr>
            <a:noAutofit/>
          </a:bodyPr>
          <a:lstStyle/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chanism of PlexinB1-mediated regulation of allergic airway inflamm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lexin B1 expression is induced on activated CD4+ T cells. Th2 cells secrete Th2 cytokines which regulate mucin gene expression and stimulate mucus secretion by lung bronchial epithelial cells. Th2 cytokines IL-4 and IL-13 stimulate mast cell activation and degranulation whereas mast cell’s IL-4 further amplifies Th2 cell activation. IL-5 is a critical cytokine for eosinophil generation in bone marrow, recruitment into circulation, migration to lung tissue, and degranulation with a release of their toxic granule proteins causing damage to lung tissues. B cells get activated by Th2 cells through allergen epitope presentation and by Th2 cytokines to switch to allergen-specific IgE (human and mouse allergic response) and IgG1 (mouse allergic response) secretion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f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play a Th2-independent stimulatory role in B cell activation and Ig switch by early secretion of IL-4. All these immunologic processes involved in allergic inflammation can be inhibited by Treg cells mainly through their production of anti-inflammatory cytokines IL-10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F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/and by a cell-cell contact.  Plexin B1 expression on Treg cells regulates their stability and function pool using Sema4A as a ligand. The role of inducible Plexin B1 on activated bronchial epithelial cells and B cells is unknown. </a:t>
            </a:r>
          </a:p>
        </p:txBody>
      </p:sp>
    </p:spTree>
    <p:extLst>
      <p:ext uri="{BB962C8B-B14F-4D97-AF65-F5344CB8AC3E}">
        <p14:creationId xmlns:p14="http://schemas.microsoft.com/office/powerpoint/2010/main" val="4135100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277</Words>
  <Application>Microsoft Macintosh PowerPoint</Application>
  <PresentationFormat>Widescreen</PresentationFormat>
  <Paragraphs>4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</vt:vector>
  </TitlesOfParts>
  <Company>University of Maryland School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vetlana Chapoval</dc:creator>
  <cp:lastModifiedBy>Keegan, Achsah</cp:lastModifiedBy>
  <cp:revision>4</cp:revision>
  <dcterms:created xsi:type="dcterms:W3CDTF">2023-08-21T18:29:37Z</dcterms:created>
  <dcterms:modified xsi:type="dcterms:W3CDTF">2023-11-14T21:31:34Z</dcterms:modified>
</cp:coreProperties>
</file>